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Lst>
  <p:sldSz cx="12912725" cy="109807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56D9532-AB72-4C71-8BFA-BF2B17A0CB6C}" v="32" dt="2023-12-27T01:16:52.56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4" d="100"/>
          <a:sy n="84" d="100"/>
        </p:scale>
        <p:origin x="2608" y="11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yuwoong Kim" userId="c6581f603476f281" providerId="LiveId" clId="{556D9532-AB72-4C71-8BFA-BF2B17A0CB6C}"/>
    <pc:docChg chg="undo custSel modSld">
      <pc:chgData name="Kyuwoong Kim" userId="c6581f603476f281" providerId="LiveId" clId="{556D9532-AB72-4C71-8BFA-BF2B17A0CB6C}" dt="2023-12-27T04:49:01.219" v="709" actId="20577"/>
      <pc:docMkLst>
        <pc:docMk/>
      </pc:docMkLst>
      <pc:sldChg chg="addSp delSp modSp mod">
        <pc:chgData name="Kyuwoong Kim" userId="c6581f603476f281" providerId="LiveId" clId="{556D9532-AB72-4C71-8BFA-BF2B17A0CB6C}" dt="2023-12-27T04:49:01.219" v="709" actId="20577"/>
        <pc:sldMkLst>
          <pc:docMk/>
          <pc:sldMk cId="648833912" sldId="256"/>
        </pc:sldMkLst>
        <pc:spChg chg="add mod">
          <ac:chgData name="Kyuwoong Kim" userId="c6581f603476f281" providerId="LiveId" clId="{556D9532-AB72-4C71-8BFA-BF2B17A0CB6C}" dt="2023-12-27T01:17:02.742" v="699" actId="1076"/>
          <ac:spMkLst>
            <pc:docMk/>
            <pc:sldMk cId="648833912" sldId="256"/>
            <ac:spMk id="2" creationId="{FD3CC9AA-26FA-3AD2-5616-B24CBD74D53A}"/>
          </ac:spMkLst>
        </pc:spChg>
        <pc:spChg chg="add mod">
          <ac:chgData name="Kyuwoong Kim" userId="c6581f603476f281" providerId="LiveId" clId="{556D9532-AB72-4C71-8BFA-BF2B17A0CB6C}" dt="2023-12-27T01:17:02.742" v="699" actId="1076"/>
          <ac:spMkLst>
            <pc:docMk/>
            <pc:sldMk cId="648833912" sldId="256"/>
            <ac:spMk id="3" creationId="{980E1B1C-5782-65BA-EB03-E4005B456A6F}"/>
          </ac:spMkLst>
        </pc:spChg>
        <pc:spChg chg="add mod">
          <ac:chgData name="Kyuwoong Kim" userId="c6581f603476f281" providerId="LiveId" clId="{556D9532-AB72-4C71-8BFA-BF2B17A0CB6C}" dt="2023-12-27T01:17:02.742" v="699" actId="1076"/>
          <ac:spMkLst>
            <pc:docMk/>
            <pc:sldMk cId="648833912" sldId="256"/>
            <ac:spMk id="4" creationId="{1C6B68EC-F57B-C1A5-8B87-27D3DE0EA4F8}"/>
          </ac:spMkLst>
        </pc:spChg>
        <pc:spChg chg="add mod">
          <ac:chgData name="Kyuwoong Kim" userId="c6581f603476f281" providerId="LiveId" clId="{556D9532-AB72-4C71-8BFA-BF2B17A0CB6C}" dt="2023-12-27T01:17:02.742" v="699" actId="1076"/>
          <ac:spMkLst>
            <pc:docMk/>
            <pc:sldMk cId="648833912" sldId="256"/>
            <ac:spMk id="5" creationId="{027AA216-DF50-0D66-EF32-BD54A8AA60B5}"/>
          </ac:spMkLst>
        </pc:spChg>
        <pc:spChg chg="del">
          <ac:chgData name="Kyuwoong Kim" userId="c6581f603476f281" providerId="LiveId" clId="{556D9532-AB72-4C71-8BFA-BF2B17A0CB6C}" dt="2023-12-26T23:53:53.845" v="4" actId="478"/>
          <ac:spMkLst>
            <pc:docMk/>
            <pc:sldMk cId="648833912" sldId="256"/>
            <ac:spMk id="5" creationId="{FAEA2DB1-F50B-F0A4-D080-98E28C6F2E60}"/>
          </ac:spMkLst>
        </pc:spChg>
        <pc:spChg chg="add mod">
          <ac:chgData name="Kyuwoong Kim" userId="c6581f603476f281" providerId="LiveId" clId="{556D9532-AB72-4C71-8BFA-BF2B17A0CB6C}" dt="2023-12-27T01:17:02.742" v="699" actId="1076"/>
          <ac:spMkLst>
            <pc:docMk/>
            <pc:sldMk cId="648833912" sldId="256"/>
            <ac:spMk id="8" creationId="{97DD32AB-1146-40EB-3909-3D199FAB0E30}"/>
          </ac:spMkLst>
        </pc:spChg>
        <pc:spChg chg="del">
          <ac:chgData name="Kyuwoong Kim" userId="c6581f603476f281" providerId="LiveId" clId="{556D9532-AB72-4C71-8BFA-BF2B17A0CB6C}" dt="2023-12-26T23:53:53.845" v="4" actId="478"/>
          <ac:spMkLst>
            <pc:docMk/>
            <pc:sldMk cId="648833912" sldId="256"/>
            <ac:spMk id="8" creationId="{D553A7A6-7D68-32A5-7273-A9A66CE3502C}"/>
          </ac:spMkLst>
        </pc:spChg>
        <pc:spChg chg="add del mod">
          <ac:chgData name="Kyuwoong Kim" userId="c6581f603476f281" providerId="LiveId" clId="{556D9532-AB72-4C71-8BFA-BF2B17A0CB6C}" dt="2023-12-26T23:57:21.815" v="107" actId="478"/>
          <ac:spMkLst>
            <pc:docMk/>
            <pc:sldMk cId="648833912" sldId="256"/>
            <ac:spMk id="9" creationId="{2F06267E-7068-D8B5-5C35-23FCF430FD94}"/>
          </ac:spMkLst>
        </pc:spChg>
        <pc:spChg chg="add mod">
          <ac:chgData name="Kyuwoong Kim" userId="c6581f603476f281" providerId="LiveId" clId="{556D9532-AB72-4C71-8BFA-BF2B17A0CB6C}" dt="2023-12-27T04:49:01.219" v="709" actId="20577"/>
          <ac:spMkLst>
            <pc:docMk/>
            <pc:sldMk cId="648833912" sldId="256"/>
            <ac:spMk id="9" creationId="{C38CFEB1-5D97-15BA-1BB8-A579D9511F5B}"/>
          </ac:spMkLst>
        </pc:spChg>
        <pc:spChg chg="add del mod">
          <ac:chgData name="Kyuwoong Kim" userId="c6581f603476f281" providerId="LiveId" clId="{556D9532-AB72-4C71-8BFA-BF2B17A0CB6C}" dt="2023-12-26T23:57:23.084" v="109" actId="478"/>
          <ac:spMkLst>
            <pc:docMk/>
            <pc:sldMk cId="648833912" sldId="256"/>
            <ac:spMk id="10" creationId="{4C6F889B-B24B-64AE-60D6-F8504A016DC7}"/>
          </ac:spMkLst>
        </pc:spChg>
        <pc:spChg chg="del">
          <ac:chgData name="Kyuwoong Kim" userId="c6581f603476f281" providerId="LiveId" clId="{556D9532-AB72-4C71-8BFA-BF2B17A0CB6C}" dt="2023-12-26T23:53:53.845" v="4" actId="478"/>
          <ac:spMkLst>
            <pc:docMk/>
            <pc:sldMk cId="648833912" sldId="256"/>
            <ac:spMk id="11" creationId="{1B1DC1A3-A19A-5EB6-CBBB-A2FE1234B35D}"/>
          </ac:spMkLst>
        </pc:spChg>
        <pc:spChg chg="add mod">
          <ac:chgData name="Kyuwoong Kim" userId="c6581f603476f281" providerId="LiveId" clId="{556D9532-AB72-4C71-8BFA-BF2B17A0CB6C}" dt="2023-12-27T01:17:02.742" v="699" actId="1076"/>
          <ac:spMkLst>
            <pc:docMk/>
            <pc:sldMk cId="648833912" sldId="256"/>
            <ac:spMk id="11" creationId="{94EFB512-D4E6-2BFA-E7B7-A4AF376B498D}"/>
          </ac:spMkLst>
        </pc:spChg>
        <pc:spChg chg="del">
          <ac:chgData name="Kyuwoong Kim" userId="c6581f603476f281" providerId="LiveId" clId="{556D9532-AB72-4C71-8BFA-BF2B17A0CB6C}" dt="2023-12-26T23:53:53.845" v="4" actId="478"/>
          <ac:spMkLst>
            <pc:docMk/>
            <pc:sldMk cId="648833912" sldId="256"/>
            <ac:spMk id="12" creationId="{251F90EA-C15F-4776-7BAD-D7CA740247A4}"/>
          </ac:spMkLst>
        </pc:spChg>
        <pc:spChg chg="add mod">
          <ac:chgData name="Kyuwoong Kim" userId="c6581f603476f281" providerId="LiveId" clId="{556D9532-AB72-4C71-8BFA-BF2B17A0CB6C}" dt="2023-12-27T01:17:02.742" v="699" actId="1076"/>
          <ac:spMkLst>
            <pc:docMk/>
            <pc:sldMk cId="648833912" sldId="256"/>
            <ac:spMk id="12" creationId="{7E9BFFAB-13B8-AF42-8201-87FBFDA58E42}"/>
          </ac:spMkLst>
        </pc:spChg>
        <pc:spChg chg="del">
          <ac:chgData name="Kyuwoong Kim" userId="c6581f603476f281" providerId="LiveId" clId="{556D9532-AB72-4C71-8BFA-BF2B17A0CB6C}" dt="2023-12-26T23:53:53.845" v="4" actId="478"/>
          <ac:spMkLst>
            <pc:docMk/>
            <pc:sldMk cId="648833912" sldId="256"/>
            <ac:spMk id="13" creationId="{CBA48424-BA70-4B9A-9D1F-825934D0432C}"/>
          </ac:spMkLst>
        </pc:spChg>
        <pc:spChg chg="add mod">
          <ac:chgData name="Kyuwoong Kim" userId="c6581f603476f281" providerId="LiveId" clId="{556D9532-AB72-4C71-8BFA-BF2B17A0CB6C}" dt="2023-12-27T01:17:02.742" v="699" actId="1076"/>
          <ac:spMkLst>
            <pc:docMk/>
            <pc:sldMk cId="648833912" sldId="256"/>
            <ac:spMk id="13" creationId="{D471E572-B0C6-999F-59C2-61AD127B40F1}"/>
          </ac:spMkLst>
        </pc:spChg>
        <pc:spChg chg="add del mod">
          <ac:chgData name="Kyuwoong Kim" userId="c6581f603476f281" providerId="LiveId" clId="{556D9532-AB72-4C71-8BFA-BF2B17A0CB6C}" dt="2023-12-26T23:57:24.975" v="110" actId="478"/>
          <ac:spMkLst>
            <pc:docMk/>
            <pc:sldMk cId="648833912" sldId="256"/>
            <ac:spMk id="14" creationId="{31D11B23-DDDD-EDFB-BF7B-B9F9289880DC}"/>
          </ac:spMkLst>
        </pc:spChg>
        <pc:spChg chg="add mod">
          <ac:chgData name="Kyuwoong Kim" userId="c6581f603476f281" providerId="LiveId" clId="{556D9532-AB72-4C71-8BFA-BF2B17A0CB6C}" dt="2023-12-27T01:17:02.742" v="699" actId="1076"/>
          <ac:spMkLst>
            <pc:docMk/>
            <pc:sldMk cId="648833912" sldId="256"/>
            <ac:spMk id="15" creationId="{832C9E58-ED44-A228-42DE-08C68783B30B}"/>
          </ac:spMkLst>
        </pc:spChg>
        <pc:spChg chg="add mod">
          <ac:chgData name="Kyuwoong Kim" userId="c6581f603476f281" providerId="LiveId" clId="{556D9532-AB72-4C71-8BFA-BF2B17A0CB6C}" dt="2023-12-27T01:20:19.206" v="701" actId="1076"/>
          <ac:spMkLst>
            <pc:docMk/>
            <pc:sldMk cId="648833912" sldId="256"/>
            <ac:spMk id="16" creationId="{A115F86F-7F57-9521-2997-8B0366BA61C1}"/>
          </ac:spMkLst>
        </pc:spChg>
        <pc:spChg chg="add del mod">
          <ac:chgData name="Kyuwoong Kim" userId="c6581f603476f281" providerId="LiveId" clId="{556D9532-AB72-4C71-8BFA-BF2B17A0CB6C}" dt="2023-12-26T23:57:16.139" v="104" actId="478"/>
          <ac:spMkLst>
            <pc:docMk/>
            <pc:sldMk cId="648833912" sldId="256"/>
            <ac:spMk id="17" creationId="{C522D15C-F787-CC4F-FEB7-EA919E17892D}"/>
          </ac:spMkLst>
        </pc:spChg>
        <pc:spChg chg="add mod">
          <ac:chgData name="Kyuwoong Kim" userId="c6581f603476f281" providerId="LiveId" clId="{556D9532-AB72-4C71-8BFA-BF2B17A0CB6C}" dt="2023-12-27T01:20:35.837" v="704" actId="1076"/>
          <ac:spMkLst>
            <pc:docMk/>
            <pc:sldMk cId="648833912" sldId="256"/>
            <ac:spMk id="18" creationId="{2C7B121F-3BEF-3CE1-756F-B8BCEA464733}"/>
          </ac:spMkLst>
        </pc:spChg>
        <pc:spChg chg="add mod">
          <ac:chgData name="Kyuwoong Kim" userId="c6581f603476f281" providerId="LiveId" clId="{556D9532-AB72-4C71-8BFA-BF2B17A0CB6C}" dt="2023-12-27T01:20:28.409" v="703" actId="1076"/>
          <ac:spMkLst>
            <pc:docMk/>
            <pc:sldMk cId="648833912" sldId="256"/>
            <ac:spMk id="19" creationId="{C19EFB19-09EC-89F1-A1C2-F48AD3F1B295}"/>
          </ac:spMkLst>
        </pc:spChg>
        <pc:spChg chg="add del mod">
          <ac:chgData name="Kyuwoong Kim" userId="c6581f603476f281" providerId="LiveId" clId="{556D9532-AB72-4C71-8BFA-BF2B17A0CB6C}" dt="2023-12-26T23:57:34.541" v="118" actId="478"/>
          <ac:spMkLst>
            <pc:docMk/>
            <pc:sldMk cId="648833912" sldId="256"/>
            <ac:spMk id="20" creationId="{45E8F04C-DB45-ABA6-7AEC-4929D729083E}"/>
          </ac:spMkLst>
        </pc:spChg>
        <pc:spChg chg="add mod">
          <ac:chgData name="Kyuwoong Kim" userId="c6581f603476f281" providerId="LiveId" clId="{556D9532-AB72-4C71-8BFA-BF2B17A0CB6C}" dt="2023-12-27T01:17:02.742" v="699" actId="1076"/>
          <ac:spMkLst>
            <pc:docMk/>
            <pc:sldMk cId="648833912" sldId="256"/>
            <ac:spMk id="21" creationId="{52B25AC5-F550-547A-7C3C-5CC42318BBBC}"/>
          </ac:spMkLst>
        </pc:spChg>
        <pc:spChg chg="del">
          <ac:chgData name="Kyuwoong Kim" userId="c6581f603476f281" providerId="LiveId" clId="{556D9532-AB72-4C71-8BFA-BF2B17A0CB6C}" dt="2023-12-26T23:53:51.202" v="3" actId="478"/>
          <ac:spMkLst>
            <pc:docMk/>
            <pc:sldMk cId="648833912" sldId="256"/>
            <ac:spMk id="21" creationId="{62658A79-ED74-6FAE-981C-E7DE6217D7C6}"/>
          </ac:spMkLst>
        </pc:spChg>
        <pc:spChg chg="del">
          <ac:chgData name="Kyuwoong Kim" userId="c6581f603476f281" providerId="LiveId" clId="{556D9532-AB72-4C71-8BFA-BF2B17A0CB6C}" dt="2023-12-26T23:53:51.202" v="3" actId="478"/>
          <ac:spMkLst>
            <pc:docMk/>
            <pc:sldMk cId="648833912" sldId="256"/>
            <ac:spMk id="22" creationId="{C7838085-C0D9-C2EF-2121-E2058AF99563}"/>
          </ac:spMkLst>
        </pc:spChg>
        <pc:spChg chg="add mod">
          <ac:chgData name="Kyuwoong Kim" userId="c6581f603476f281" providerId="LiveId" clId="{556D9532-AB72-4C71-8BFA-BF2B17A0CB6C}" dt="2023-12-27T01:20:43.701" v="706" actId="1076"/>
          <ac:spMkLst>
            <pc:docMk/>
            <pc:sldMk cId="648833912" sldId="256"/>
            <ac:spMk id="22" creationId="{F38EBE54-0362-C1B9-13EE-13306B3E6B30}"/>
          </ac:spMkLst>
        </pc:spChg>
        <pc:spChg chg="del">
          <ac:chgData name="Kyuwoong Kim" userId="c6581f603476f281" providerId="LiveId" clId="{556D9532-AB72-4C71-8BFA-BF2B17A0CB6C}" dt="2023-12-26T23:53:53.845" v="4" actId="478"/>
          <ac:spMkLst>
            <pc:docMk/>
            <pc:sldMk cId="648833912" sldId="256"/>
            <ac:spMk id="23" creationId="{8E53A1CF-FE7C-1C53-CA6B-D110B5B0CF6C}"/>
          </ac:spMkLst>
        </pc:spChg>
        <pc:spChg chg="del">
          <ac:chgData name="Kyuwoong Kim" userId="c6581f603476f281" providerId="LiveId" clId="{556D9532-AB72-4C71-8BFA-BF2B17A0CB6C}" dt="2023-12-26T23:53:53.845" v="4" actId="478"/>
          <ac:spMkLst>
            <pc:docMk/>
            <pc:sldMk cId="648833912" sldId="256"/>
            <ac:spMk id="24" creationId="{87BEB7EB-53A9-6261-6205-F559A8E8254B}"/>
          </ac:spMkLst>
        </pc:spChg>
        <pc:spChg chg="del">
          <ac:chgData name="Kyuwoong Kim" userId="c6581f603476f281" providerId="LiveId" clId="{556D9532-AB72-4C71-8BFA-BF2B17A0CB6C}" dt="2023-12-26T23:53:55.444" v="5" actId="478"/>
          <ac:spMkLst>
            <pc:docMk/>
            <pc:sldMk cId="648833912" sldId="256"/>
            <ac:spMk id="25" creationId="{7E968179-7680-E8FA-AAF3-46B859076AE8}"/>
          </ac:spMkLst>
        </pc:spChg>
        <pc:spChg chg="del">
          <ac:chgData name="Kyuwoong Kim" userId="c6581f603476f281" providerId="LiveId" clId="{556D9532-AB72-4C71-8BFA-BF2B17A0CB6C}" dt="2023-12-26T23:53:53.845" v="4" actId="478"/>
          <ac:spMkLst>
            <pc:docMk/>
            <pc:sldMk cId="648833912" sldId="256"/>
            <ac:spMk id="28" creationId="{6CC523FB-2017-9330-E464-B51CED8C8523}"/>
          </ac:spMkLst>
        </pc:spChg>
        <pc:spChg chg="del">
          <ac:chgData name="Kyuwoong Kim" userId="c6581f603476f281" providerId="LiveId" clId="{556D9532-AB72-4C71-8BFA-BF2B17A0CB6C}" dt="2023-12-26T23:53:53.845" v="4" actId="478"/>
          <ac:spMkLst>
            <pc:docMk/>
            <pc:sldMk cId="648833912" sldId="256"/>
            <ac:spMk id="29" creationId="{84D997AF-10C2-7BCE-7E4B-900B41D3F831}"/>
          </ac:spMkLst>
        </pc:spChg>
        <pc:spChg chg="del">
          <ac:chgData name="Kyuwoong Kim" userId="c6581f603476f281" providerId="LiveId" clId="{556D9532-AB72-4C71-8BFA-BF2B17A0CB6C}" dt="2023-12-26T23:53:55.444" v="5" actId="478"/>
          <ac:spMkLst>
            <pc:docMk/>
            <pc:sldMk cId="648833912" sldId="256"/>
            <ac:spMk id="30" creationId="{4335569D-7366-F6A9-F34B-05B3CA2358D7}"/>
          </ac:spMkLst>
        </pc:spChg>
        <pc:spChg chg="del">
          <ac:chgData name="Kyuwoong Kim" userId="c6581f603476f281" providerId="LiveId" clId="{556D9532-AB72-4C71-8BFA-BF2B17A0CB6C}" dt="2023-12-26T23:53:53.845" v="4" actId="478"/>
          <ac:spMkLst>
            <pc:docMk/>
            <pc:sldMk cId="648833912" sldId="256"/>
            <ac:spMk id="31" creationId="{3E544B73-14FB-8C0A-54BB-F1BA0C604724}"/>
          </ac:spMkLst>
        </pc:spChg>
        <pc:spChg chg="del">
          <ac:chgData name="Kyuwoong Kim" userId="c6581f603476f281" providerId="LiveId" clId="{556D9532-AB72-4C71-8BFA-BF2B17A0CB6C}" dt="2023-12-26T23:53:51.202" v="3" actId="478"/>
          <ac:spMkLst>
            <pc:docMk/>
            <pc:sldMk cId="648833912" sldId="256"/>
            <ac:spMk id="32" creationId="{4678528B-DB09-94AB-B587-41D5198D9A26}"/>
          </ac:spMkLst>
        </pc:spChg>
        <pc:spChg chg="del">
          <ac:chgData name="Kyuwoong Kim" userId="c6581f603476f281" providerId="LiveId" clId="{556D9532-AB72-4C71-8BFA-BF2B17A0CB6C}" dt="2023-12-26T23:53:51.202" v="3" actId="478"/>
          <ac:spMkLst>
            <pc:docMk/>
            <pc:sldMk cId="648833912" sldId="256"/>
            <ac:spMk id="33" creationId="{61971DD9-EE9D-3C64-F8DD-8183D3D3456F}"/>
          </ac:spMkLst>
        </pc:spChg>
        <pc:spChg chg="del">
          <ac:chgData name="Kyuwoong Kim" userId="c6581f603476f281" providerId="LiveId" clId="{556D9532-AB72-4C71-8BFA-BF2B17A0CB6C}" dt="2023-12-26T23:53:51.202" v="3" actId="478"/>
          <ac:spMkLst>
            <pc:docMk/>
            <pc:sldMk cId="648833912" sldId="256"/>
            <ac:spMk id="34" creationId="{80FA53D5-FEE6-02E5-6DE0-C9E26F2331AB}"/>
          </ac:spMkLst>
        </pc:spChg>
        <pc:spChg chg="del">
          <ac:chgData name="Kyuwoong Kim" userId="c6581f603476f281" providerId="LiveId" clId="{556D9532-AB72-4C71-8BFA-BF2B17A0CB6C}" dt="2023-12-26T23:53:51.202" v="3" actId="478"/>
          <ac:spMkLst>
            <pc:docMk/>
            <pc:sldMk cId="648833912" sldId="256"/>
            <ac:spMk id="35" creationId="{3B5806F3-36F5-6DF5-0AF2-60DF275BB797}"/>
          </ac:spMkLst>
        </pc:spChg>
        <pc:spChg chg="del">
          <ac:chgData name="Kyuwoong Kim" userId="c6581f603476f281" providerId="LiveId" clId="{556D9532-AB72-4C71-8BFA-BF2B17A0CB6C}" dt="2023-12-26T23:53:55.444" v="5" actId="478"/>
          <ac:spMkLst>
            <pc:docMk/>
            <pc:sldMk cId="648833912" sldId="256"/>
            <ac:spMk id="36" creationId="{B7EEE248-8304-9643-3D5B-3A97CA501CAE}"/>
          </ac:spMkLst>
        </pc:spChg>
        <pc:spChg chg="del">
          <ac:chgData name="Kyuwoong Kim" userId="c6581f603476f281" providerId="LiveId" clId="{556D9532-AB72-4C71-8BFA-BF2B17A0CB6C}" dt="2023-12-26T23:53:53.845" v="4" actId="478"/>
          <ac:spMkLst>
            <pc:docMk/>
            <pc:sldMk cId="648833912" sldId="256"/>
            <ac:spMk id="37" creationId="{5179028C-B7AA-2FD1-3382-46A04DAF1845}"/>
          </ac:spMkLst>
        </pc:spChg>
        <pc:spChg chg="add mod">
          <ac:chgData name="Kyuwoong Kim" userId="c6581f603476f281" providerId="LiveId" clId="{556D9532-AB72-4C71-8BFA-BF2B17A0CB6C}" dt="2023-12-27T01:17:02.742" v="699" actId="1076"/>
          <ac:spMkLst>
            <pc:docMk/>
            <pc:sldMk cId="648833912" sldId="256"/>
            <ac:spMk id="38" creationId="{549A40D2-B161-41AC-AD42-9BBE11DBEF59}"/>
          </ac:spMkLst>
        </pc:spChg>
        <pc:spChg chg="add mod">
          <ac:chgData name="Kyuwoong Kim" userId="c6581f603476f281" providerId="LiveId" clId="{556D9532-AB72-4C71-8BFA-BF2B17A0CB6C}" dt="2023-12-27T01:17:02.742" v="699" actId="1076"/>
          <ac:spMkLst>
            <pc:docMk/>
            <pc:sldMk cId="648833912" sldId="256"/>
            <ac:spMk id="39" creationId="{0C2D4290-83CA-546A-268C-60FFDCA6B305}"/>
          </ac:spMkLst>
        </pc:spChg>
        <pc:spChg chg="add mod">
          <ac:chgData name="Kyuwoong Kim" userId="c6581f603476f281" providerId="LiveId" clId="{556D9532-AB72-4C71-8BFA-BF2B17A0CB6C}" dt="2023-12-27T01:17:02.742" v="699" actId="1076"/>
          <ac:spMkLst>
            <pc:docMk/>
            <pc:sldMk cId="648833912" sldId="256"/>
            <ac:spMk id="40" creationId="{90309B63-1CFE-2EFE-B9B5-8D7A365C6ACC}"/>
          </ac:spMkLst>
        </pc:spChg>
        <pc:spChg chg="add del mod">
          <ac:chgData name="Kyuwoong Kim" userId="c6581f603476f281" providerId="LiveId" clId="{556D9532-AB72-4C71-8BFA-BF2B17A0CB6C}" dt="2023-12-26T23:58:03.399" v="134" actId="478"/>
          <ac:spMkLst>
            <pc:docMk/>
            <pc:sldMk cId="648833912" sldId="256"/>
            <ac:spMk id="45" creationId="{957CFF35-5125-7D58-0D8E-6070F60F535E}"/>
          </ac:spMkLst>
        </pc:spChg>
        <pc:spChg chg="add del mod">
          <ac:chgData name="Kyuwoong Kim" userId="c6581f603476f281" providerId="LiveId" clId="{556D9532-AB72-4C71-8BFA-BF2B17A0CB6C}" dt="2023-12-26T23:58:04.714" v="135" actId="478"/>
          <ac:spMkLst>
            <pc:docMk/>
            <pc:sldMk cId="648833912" sldId="256"/>
            <ac:spMk id="46" creationId="{2EB034BA-3C50-8095-3123-0326342D765B}"/>
          </ac:spMkLst>
        </pc:spChg>
        <pc:spChg chg="add del mod">
          <ac:chgData name="Kyuwoong Kim" userId="c6581f603476f281" providerId="LiveId" clId="{556D9532-AB72-4C71-8BFA-BF2B17A0CB6C}" dt="2023-12-26T23:58:08.060" v="137" actId="478"/>
          <ac:spMkLst>
            <pc:docMk/>
            <pc:sldMk cId="648833912" sldId="256"/>
            <ac:spMk id="47" creationId="{9B69C710-DE2D-1BAC-FADB-7DA4A024CE07}"/>
          </ac:spMkLst>
        </pc:spChg>
        <pc:spChg chg="add del mod">
          <ac:chgData name="Kyuwoong Kim" userId="c6581f603476f281" providerId="LiveId" clId="{556D9532-AB72-4C71-8BFA-BF2B17A0CB6C}" dt="2023-12-26T23:58:01.112" v="133" actId="478"/>
          <ac:spMkLst>
            <pc:docMk/>
            <pc:sldMk cId="648833912" sldId="256"/>
            <ac:spMk id="48" creationId="{67E3E48D-6F27-34D7-2844-6629C41D4F8F}"/>
          </ac:spMkLst>
        </pc:spChg>
        <pc:spChg chg="add del mod">
          <ac:chgData name="Kyuwoong Kim" userId="c6581f603476f281" providerId="LiveId" clId="{556D9532-AB72-4C71-8BFA-BF2B17A0CB6C}" dt="2023-12-26T23:58:06.046" v="136" actId="478"/>
          <ac:spMkLst>
            <pc:docMk/>
            <pc:sldMk cId="648833912" sldId="256"/>
            <ac:spMk id="49" creationId="{E07270A3-BCC4-7098-3E10-099F1DD8C4D1}"/>
          </ac:spMkLst>
        </pc:spChg>
        <pc:spChg chg="add del mod">
          <ac:chgData name="Kyuwoong Kim" userId="c6581f603476f281" providerId="LiveId" clId="{556D9532-AB72-4C71-8BFA-BF2B17A0CB6C}" dt="2023-12-26T23:58:09.037" v="138" actId="478"/>
          <ac:spMkLst>
            <pc:docMk/>
            <pc:sldMk cId="648833912" sldId="256"/>
            <ac:spMk id="50" creationId="{3AE3F4EE-4D07-FA75-7451-4BA19A6D12E7}"/>
          </ac:spMkLst>
        </pc:spChg>
        <pc:spChg chg="add mod">
          <ac:chgData name="Kyuwoong Kim" userId="c6581f603476f281" providerId="LiveId" clId="{556D9532-AB72-4C71-8BFA-BF2B17A0CB6C}" dt="2023-12-27T01:17:02.742" v="699" actId="1076"/>
          <ac:spMkLst>
            <pc:docMk/>
            <pc:sldMk cId="648833912" sldId="256"/>
            <ac:spMk id="51" creationId="{958350B1-BEF6-2452-8208-F4A3A8ED5EA4}"/>
          </ac:spMkLst>
        </pc:spChg>
        <pc:spChg chg="add mod">
          <ac:chgData name="Kyuwoong Kim" userId="c6581f603476f281" providerId="LiveId" clId="{556D9532-AB72-4C71-8BFA-BF2B17A0CB6C}" dt="2023-12-27T01:17:02.742" v="699" actId="1076"/>
          <ac:spMkLst>
            <pc:docMk/>
            <pc:sldMk cId="648833912" sldId="256"/>
            <ac:spMk id="52" creationId="{AF566DC3-DBE2-50A7-D072-B6DF87688FC9}"/>
          </ac:spMkLst>
        </pc:spChg>
        <pc:spChg chg="add mod">
          <ac:chgData name="Kyuwoong Kim" userId="c6581f603476f281" providerId="LiveId" clId="{556D9532-AB72-4C71-8BFA-BF2B17A0CB6C}" dt="2023-12-27T01:17:02.742" v="699" actId="1076"/>
          <ac:spMkLst>
            <pc:docMk/>
            <pc:sldMk cId="648833912" sldId="256"/>
            <ac:spMk id="53" creationId="{6D8DAF6A-D9D3-46E5-D0A4-12BAAAF7245E}"/>
          </ac:spMkLst>
        </pc:spChg>
        <pc:grpChg chg="del">
          <ac:chgData name="Kyuwoong Kim" userId="c6581f603476f281" providerId="LiveId" clId="{556D9532-AB72-4C71-8BFA-BF2B17A0CB6C}" dt="2023-12-26T23:53:55.444" v="5" actId="478"/>
          <ac:grpSpMkLst>
            <pc:docMk/>
            <pc:sldMk cId="648833912" sldId="256"/>
            <ac:grpSpMk id="16" creationId="{DF6075C8-D9A8-1BA5-6729-88B15C885B2D}"/>
          </ac:grpSpMkLst>
        </pc:grpChg>
        <pc:picChg chg="del">
          <ac:chgData name="Kyuwoong Kim" userId="c6581f603476f281" providerId="LiveId" clId="{556D9532-AB72-4C71-8BFA-BF2B17A0CB6C}" dt="2023-12-26T23:53:53.845" v="4" actId="478"/>
          <ac:picMkLst>
            <pc:docMk/>
            <pc:sldMk cId="648833912" sldId="256"/>
            <ac:picMk id="2" creationId="{A7E0DEB9-D172-D4CE-9CC1-F9C55B63D1A8}"/>
          </ac:picMkLst>
        </pc:picChg>
        <pc:picChg chg="del">
          <ac:chgData name="Kyuwoong Kim" userId="c6581f603476f281" providerId="LiveId" clId="{556D9532-AB72-4C71-8BFA-BF2B17A0CB6C}" dt="2023-12-26T23:53:53.845" v="4" actId="478"/>
          <ac:picMkLst>
            <pc:docMk/>
            <pc:sldMk cId="648833912" sldId="256"/>
            <ac:picMk id="3" creationId="{A0A6CB00-12F0-B4E9-88A2-B06026F9DA91}"/>
          </ac:picMkLst>
        </pc:picChg>
        <pc:picChg chg="del">
          <ac:chgData name="Kyuwoong Kim" userId="c6581f603476f281" providerId="LiveId" clId="{556D9532-AB72-4C71-8BFA-BF2B17A0CB6C}" dt="2023-12-26T23:53:53.845" v="4" actId="478"/>
          <ac:picMkLst>
            <pc:docMk/>
            <pc:sldMk cId="648833912" sldId="256"/>
            <ac:picMk id="4" creationId="{F3923BCE-31B9-CA0F-397E-B63633BEBADB}"/>
          </ac:picMkLst>
        </pc:picChg>
        <pc:picChg chg="add mod">
          <ac:chgData name="Kyuwoong Kim" userId="c6581f603476f281" providerId="LiveId" clId="{556D9532-AB72-4C71-8BFA-BF2B17A0CB6C}" dt="2023-12-27T01:17:02.742" v="699" actId="1076"/>
          <ac:picMkLst>
            <pc:docMk/>
            <pc:sldMk cId="648833912" sldId="256"/>
            <ac:picMk id="6" creationId="{2E0E3B99-2D8A-1654-1D9E-E8E5DC6EE455}"/>
          </ac:picMkLst>
        </pc:picChg>
        <pc:picChg chg="add mod">
          <ac:chgData name="Kyuwoong Kim" userId="c6581f603476f281" providerId="LiveId" clId="{556D9532-AB72-4C71-8BFA-BF2B17A0CB6C}" dt="2023-12-27T01:17:02.742" v="699" actId="1076"/>
          <ac:picMkLst>
            <pc:docMk/>
            <pc:sldMk cId="648833912" sldId="256"/>
            <ac:picMk id="7" creationId="{6EC75941-0253-1363-18C9-092E3CF758D1}"/>
          </ac:picMkLst>
        </pc:picChg>
        <pc:picChg chg="del">
          <ac:chgData name="Kyuwoong Kim" userId="c6581f603476f281" providerId="LiveId" clId="{556D9532-AB72-4C71-8BFA-BF2B17A0CB6C}" dt="2023-12-26T23:53:48.624" v="0" actId="478"/>
          <ac:picMkLst>
            <pc:docMk/>
            <pc:sldMk cId="648833912" sldId="256"/>
            <ac:picMk id="15" creationId="{23B2810A-7602-6CA4-4CB2-C591CF3DA2A5}"/>
          </ac:picMkLst>
        </pc:picChg>
        <pc:picChg chg="del">
          <ac:chgData name="Kyuwoong Kim" userId="c6581f603476f281" providerId="LiveId" clId="{556D9532-AB72-4C71-8BFA-BF2B17A0CB6C}" dt="2023-12-26T23:53:48.974" v="1" actId="478"/>
          <ac:picMkLst>
            <pc:docMk/>
            <pc:sldMk cId="648833912" sldId="256"/>
            <ac:picMk id="26" creationId="{07FCE925-4484-CCCE-19AD-B78566DC0BC1}"/>
          </ac:picMkLst>
        </pc:picChg>
        <pc:picChg chg="del">
          <ac:chgData name="Kyuwoong Kim" userId="c6581f603476f281" providerId="LiveId" clId="{556D9532-AB72-4C71-8BFA-BF2B17A0CB6C}" dt="2023-12-26T23:53:49.350" v="2" actId="478"/>
          <ac:picMkLst>
            <pc:docMk/>
            <pc:sldMk cId="648833912" sldId="256"/>
            <ac:picMk id="27" creationId="{250591F6-C4B2-33FA-F314-E5035DD94202}"/>
          </ac:picMkLst>
        </pc:picChg>
        <pc:picChg chg="add mod">
          <ac:chgData name="Kyuwoong Kim" userId="c6581f603476f281" providerId="LiveId" clId="{556D9532-AB72-4C71-8BFA-BF2B17A0CB6C}" dt="2023-12-27T01:17:02.742" v="699" actId="1076"/>
          <ac:picMkLst>
            <pc:docMk/>
            <pc:sldMk cId="648833912" sldId="256"/>
            <ac:picMk id="41" creationId="{5A214A41-6125-1A42-AE2D-79CB4584ECFD}"/>
          </ac:picMkLst>
        </pc:picChg>
        <pc:picChg chg="add mod">
          <ac:chgData name="Kyuwoong Kim" userId="c6581f603476f281" providerId="LiveId" clId="{556D9532-AB72-4C71-8BFA-BF2B17A0CB6C}" dt="2023-12-27T01:20:39.958" v="705" actId="14100"/>
          <ac:picMkLst>
            <pc:docMk/>
            <pc:sldMk cId="648833912" sldId="256"/>
            <ac:picMk id="42" creationId="{6F25A9B9-D76D-3E46-25B7-79D914A658F2}"/>
          </ac:picMkLst>
        </pc:picChg>
        <pc:picChg chg="add mod">
          <ac:chgData name="Kyuwoong Kim" userId="c6581f603476f281" providerId="LiveId" clId="{556D9532-AB72-4C71-8BFA-BF2B17A0CB6C}" dt="2023-12-27T01:20:22.527" v="702" actId="14100"/>
          <ac:picMkLst>
            <pc:docMk/>
            <pc:sldMk cId="648833912" sldId="256"/>
            <ac:picMk id="43" creationId="{AF8077C5-FE9A-A0AF-1A5A-CD3D3B7AE75E}"/>
          </ac:picMkLst>
        </pc:picChg>
        <pc:picChg chg="add mod">
          <ac:chgData name="Kyuwoong Kim" userId="c6581f603476f281" providerId="LiveId" clId="{556D9532-AB72-4C71-8BFA-BF2B17A0CB6C}" dt="2023-12-27T01:17:02.742" v="699" actId="1076"/>
          <ac:picMkLst>
            <pc:docMk/>
            <pc:sldMk cId="648833912" sldId="256"/>
            <ac:picMk id="44" creationId="{3D3F847B-2BE8-9E25-E12D-17BCDF229CB5}"/>
          </ac:picMkLst>
        </pc:picChg>
      </pc:sldChg>
    </pc:docChg>
  </pc:docChgLst>
  <pc:docChgLst>
    <pc:chgData name="Kyuwoong Kim" userId="c6581f603476f281" providerId="LiveId" clId="{4C2B3B1C-2310-4AB4-A954-ADC28E335756}"/>
    <pc:docChg chg="undo custSel addSld delSld modSld sldOrd">
      <pc:chgData name="Kyuwoong Kim" userId="c6581f603476f281" providerId="LiveId" clId="{4C2B3B1C-2310-4AB4-A954-ADC28E335756}" dt="2023-12-26T06:19:09.636" v="565" actId="1076"/>
      <pc:docMkLst>
        <pc:docMk/>
      </pc:docMkLst>
      <pc:sldChg chg="addSp delSp modSp new mod">
        <pc:chgData name="Kyuwoong Kim" userId="c6581f603476f281" providerId="LiveId" clId="{4C2B3B1C-2310-4AB4-A954-ADC28E335756}" dt="2023-12-26T06:19:09.636" v="565" actId="1076"/>
        <pc:sldMkLst>
          <pc:docMk/>
          <pc:sldMk cId="648833912" sldId="256"/>
        </pc:sldMkLst>
        <pc:spChg chg="add mod">
          <ac:chgData name="Kyuwoong Kim" userId="c6581f603476f281" providerId="LiveId" clId="{4C2B3B1C-2310-4AB4-A954-ADC28E335756}" dt="2023-12-22T02:35:22.208" v="385" actId="403"/>
          <ac:spMkLst>
            <pc:docMk/>
            <pc:sldMk cId="648833912" sldId="256"/>
            <ac:spMk id="5" creationId="{FAEA2DB1-F50B-F0A4-D080-98E28C6F2E60}"/>
          </ac:spMkLst>
        </pc:spChg>
        <pc:spChg chg="add del mod">
          <ac:chgData name="Kyuwoong Kim" userId="c6581f603476f281" providerId="LiveId" clId="{4C2B3B1C-2310-4AB4-A954-ADC28E335756}" dt="2023-12-22T02:35:49.042" v="388" actId="478"/>
          <ac:spMkLst>
            <pc:docMk/>
            <pc:sldMk cId="648833912" sldId="256"/>
            <ac:spMk id="6" creationId="{E8DFCCDF-13EF-6AA2-C66C-413D916B314C}"/>
          </ac:spMkLst>
        </pc:spChg>
        <pc:spChg chg="add del mod">
          <ac:chgData name="Kyuwoong Kim" userId="c6581f603476f281" providerId="LiveId" clId="{4C2B3B1C-2310-4AB4-A954-ADC28E335756}" dt="2023-12-22T02:35:52.378" v="390" actId="478"/>
          <ac:spMkLst>
            <pc:docMk/>
            <pc:sldMk cId="648833912" sldId="256"/>
            <ac:spMk id="7" creationId="{FC4F9864-A538-399A-9F20-B807CDFC6B04}"/>
          </ac:spMkLst>
        </pc:spChg>
        <pc:spChg chg="add mod">
          <ac:chgData name="Kyuwoong Kim" userId="c6581f603476f281" providerId="LiveId" clId="{4C2B3B1C-2310-4AB4-A954-ADC28E335756}" dt="2023-12-22T02:34:12.188" v="363"/>
          <ac:spMkLst>
            <pc:docMk/>
            <pc:sldMk cId="648833912" sldId="256"/>
            <ac:spMk id="8" creationId="{D553A7A6-7D68-32A5-7273-A9A66CE3502C}"/>
          </ac:spMkLst>
        </pc:spChg>
        <pc:spChg chg="add del mod">
          <ac:chgData name="Kyuwoong Kim" userId="c6581f603476f281" providerId="LiveId" clId="{4C2B3B1C-2310-4AB4-A954-ADC28E335756}" dt="2023-12-22T02:35:44.910" v="386" actId="478"/>
          <ac:spMkLst>
            <pc:docMk/>
            <pc:sldMk cId="648833912" sldId="256"/>
            <ac:spMk id="9" creationId="{5BE2A2B9-9C8D-ECE1-16AD-619429108F39}"/>
          </ac:spMkLst>
        </pc:spChg>
        <pc:spChg chg="add del mod">
          <ac:chgData name="Kyuwoong Kim" userId="c6581f603476f281" providerId="LiveId" clId="{4C2B3B1C-2310-4AB4-A954-ADC28E335756}" dt="2023-12-22T02:36:32.109" v="404" actId="478"/>
          <ac:spMkLst>
            <pc:docMk/>
            <pc:sldMk cId="648833912" sldId="256"/>
            <ac:spMk id="10" creationId="{DCA13580-D18C-54D9-3251-C46684F83761}"/>
          </ac:spMkLst>
        </pc:spChg>
        <pc:spChg chg="add mod">
          <ac:chgData name="Kyuwoong Kim" userId="c6581f603476f281" providerId="LiveId" clId="{4C2B3B1C-2310-4AB4-A954-ADC28E335756}" dt="2023-12-26T04:40:58.141" v="562" actId="20577"/>
          <ac:spMkLst>
            <pc:docMk/>
            <pc:sldMk cId="648833912" sldId="256"/>
            <ac:spMk id="11" creationId="{1B1DC1A3-A19A-5EB6-CBBB-A2FE1234B35D}"/>
          </ac:spMkLst>
        </pc:spChg>
        <pc:spChg chg="add mod">
          <ac:chgData name="Kyuwoong Kim" userId="c6581f603476f281" providerId="LiveId" clId="{4C2B3B1C-2310-4AB4-A954-ADC28E335756}" dt="2023-12-26T04:40:53.342" v="558" actId="20577"/>
          <ac:spMkLst>
            <pc:docMk/>
            <pc:sldMk cId="648833912" sldId="256"/>
            <ac:spMk id="12" creationId="{251F90EA-C15F-4776-7BAD-D7CA740247A4}"/>
          </ac:spMkLst>
        </pc:spChg>
        <pc:spChg chg="add mod">
          <ac:chgData name="Kyuwoong Kim" userId="c6581f603476f281" providerId="LiveId" clId="{4C2B3B1C-2310-4AB4-A954-ADC28E335756}" dt="2023-12-26T04:40:49.917" v="555" actId="20577"/>
          <ac:spMkLst>
            <pc:docMk/>
            <pc:sldMk cId="648833912" sldId="256"/>
            <ac:spMk id="13" creationId="{CBA48424-BA70-4B9A-9D1F-825934D0432C}"/>
          </ac:spMkLst>
        </pc:spChg>
        <pc:spChg chg="add del mod">
          <ac:chgData name="Kyuwoong Kim" userId="c6581f603476f281" providerId="LiveId" clId="{4C2B3B1C-2310-4AB4-A954-ADC28E335756}" dt="2023-12-22T02:35:50.590" v="389" actId="478"/>
          <ac:spMkLst>
            <pc:docMk/>
            <pc:sldMk cId="648833912" sldId="256"/>
            <ac:spMk id="14" creationId="{AFE7546C-3900-27DF-723F-B5A6227063E6}"/>
          </ac:spMkLst>
        </pc:spChg>
        <pc:spChg chg="del mod">
          <ac:chgData name="Kyuwoong Kim" userId="c6581f603476f281" providerId="LiveId" clId="{4C2B3B1C-2310-4AB4-A954-ADC28E335756}" dt="2023-12-22T02:37:37.418" v="410" actId="478"/>
          <ac:spMkLst>
            <pc:docMk/>
            <pc:sldMk cId="648833912" sldId="256"/>
            <ac:spMk id="17" creationId="{EB150AC0-7753-8BC2-E551-5C7EB2C10167}"/>
          </ac:spMkLst>
        </pc:spChg>
        <pc:spChg chg="mod">
          <ac:chgData name="Kyuwoong Kim" userId="c6581f603476f281" providerId="LiveId" clId="{4C2B3B1C-2310-4AB4-A954-ADC28E335756}" dt="2023-12-22T02:13:23.548" v="39"/>
          <ac:spMkLst>
            <pc:docMk/>
            <pc:sldMk cId="648833912" sldId="256"/>
            <ac:spMk id="18" creationId="{DCEC5AD1-D57A-9C1E-C874-DA64F849726E}"/>
          </ac:spMkLst>
        </pc:spChg>
        <pc:spChg chg="mod">
          <ac:chgData name="Kyuwoong Kim" userId="c6581f603476f281" providerId="LiveId" clId="{4C2B3B1C-2310-4AB4-A954-ADC28E335756}" dt="2023-12-22T02:13:23.548" v="39"/>
          <ac:spMkLst>
            <pc:docMk/>
            <pc:sldMk cId="648833912" sldId="256"/>
            <ac:spMk id="19" creationId="{F2DA1553-E2E1-263E-8B3D-6FED535EDEF6}"/>
          </ac:spMkLst>
        </pc:spChg>
        <pc:spChg chg="add del mod">
          <ac:chgData name="Kyuwoong Kim" userId="c6581f603476f281" providerId="LiveId" clId="{4C2B3B1C-2310-4AB4-A954-ADC28E335756}" dt="2023-12-22T02:37:35.619" v="409" actId="478"/>
          <ac:spMkLst>
            <pc:docMk/>
            <pc:sldMk cId="648833912" sldId="256"/>
            <ac:spMk id="20" creationId="{F8E4B0C9-E50D-FCA4-9F0C-57A91AC04197}"/>
          </ac:spMkLst>
        </pc:spChg>
        <pc:spChg chg="add mod">
          <ac:chgData name="Kyuwoong Kim" userId="c6581f603476f281" providerId="LiveId" clId="{4C2B3B1C-2310-4AB4-A954-ADC28E335756}" dt="2023-12-22T02:39:40.130" v="436" actId="1076"/>
          <ac:spMkLst>
            <pc:docMk/>
            <pc:sldMk cId="648833912" sldId="256"/>
            <ac:spMk id="21" creationId="{62658A79-ED74-6FAE-981C-E7DE6217D7C6}"/>
          </ac:spMkLst>
        </pc:spChg>
        <pc:spChg chg="add mod">
          <ac:chgData name="Kyuwoong Kim" userId="c6581f603476f281" providerId="LiveId" clId="{4C2B3B1C-2310-4AB4-A954-ADC28E335756}" dt="2023-12-22T02:39:40.130" v="436" actId="1076"/>
          <ac:spMkLst>
            <pc:docMk/>
            <pc:sldMk cId="648833912" sldId="256"/>
            <ac:spMk id="22" creationId="{C7838085-C0D9-C2EF-2121-E2058AF99563}"/>
          </ac:spMkLst>
        </pc:spChg>
        <pc:spChg chg="add mod">
          <ac:chgData name="Kyuwoong Kim" userId="c6581f603476f281" providerId="LiveId" clId="{4C2B3B1C-2310-4AB4-A954-ADC28E335756}" dt="2023-12-26T04:40:30.152" v="534" actId="20577"/>
          <ac:spMkLst>
            <pc:docMk/>
            <pc:sldMk cId="648833912" sldId="256"/>
            <ac:spMk id="23" creationId="{8E53A1CF-FE7C-1C53-CA6B-D110B5B0CF6C}"/>
          </ac:spMkLst>
        </pc:spChg>
        <pc:spChg chg="add mod">
          <ac:chgData name="Kyuwoong Kim" userId="c6581f603476f281" providerId="LiveId" clId="{4C2B3B1C-2310-4AB4-A954-ADC28E335756}" dt="2023-12-26T04:40:37.622" v="543" actId="20577"/>
          <ac:spMkLst>
            <pc:docMk/>
            <pc:sldMk cId="648833912" sldId="256"/>
            <ac:spMk id="24" creationId="{87BEB7EB-53A9-6261-6205-F559A8E8254B}"/>
          </ac:spMkLst>
        </pc:spChg>
        <pc:spChg chg="add mod">
          <ac:chgData name="Kyuwoong Kim" userId="c6581f603476f281" providerId="LiveId" clId="{4C2B3B1C-2310-4AB4-A954-ADC28E335756}" dt="2023-12-26T04:40:46.630" v="552" actId="20577"/>
          <ac:spMkLst>
            <pc:docMk/>
            <pc:sldMk cId="648833912" sldId="256"/>
            <ac:spMk id="25" creationId="{7E968179-7680-E8FA-AAF3-46B859076AE8}"/>
          </ac:spMkLst>
        </pc:spChg>
        <pc:spChg chg="add mod">
          <ac:chgData name="Kyuwoong Kim" userId="c6581f603476f281" providerId="LiveId" clId="{4C2B3B1C-2310-4AB4-A954-ADC28E335756}" dt="2023-12-22T02:36:00.888" v="392" actId="1076"/>
          <ac:spMkLst>
            <pc:docMk/>
            <pc:sldMk cId="648833912" sldId="256"/>
            <ac:spMk id="28" creationId="{6CC523FB-2017-9330-E464-B51CED8C8523}"/>
          </ac:spMkLst>
        </pc:spChg>
        <pc:spChg chg="add mod">
          <ac:chgData name="Kyuwoong Kim" userId="c6581f603476f281" providerId="LiveId" clId="{4C2B3B1C-2310-4AB4-A954-ADC28E335756}" dt="2023-12-22T02:36:00.888" v="392" actId="1076"/>
          <ac:spMkLst>
            <pc:docMk/>
            <pc:sldMk cId="648833912" sldId="256"/>
            <ac:spMk id="29" creationId="{84D997AF-10C2-7BCE-7E4B-900B41D3F831}"/>
          </ac:spMkLst>
        </pc:spChg>
        <pc:spChg chg="add mod">
          <ac:chgData name="Kyuwoong Kim" userId="c6581f603476f281" providerId="LiveId" clId="{4C2B3B1C-2310-4AB4-A954-ADC28E335756}" dt="2023-12-22T02:36:16.163" v="395" actId="1076"/>
          <ac:spMkLst>
            <pc:docMk/>
            <pc:sldMk cId="648833912" sldId="256"/>
            <ac:spMk id="30" creationId="{4335569D-7366-F6A9-F34B-05B3CA2358D7}"/>
          </ac:spMkLst>
        </pc:spChg>
        <pc:spChg chg="add mod">
          <ac:chgData name="Kyuwoong Kim" userId="c6581f603476f281" providerId="LiveId" clId="{4C2B3B1C-2310-4AB4-A954-ADC28E335756}" dt="2023-12-22T02:37:25.698" v="408" actId="1076"/>
          <ac:spMkLst>
            <pc:docMk/>
            <pc:sldMk cId="648833912" sldId="256"/>
            <ac:spMk id="31" creationId="{3E544B73-14FB-8C0A-54BB-F1BA0C604724}"/>
          </ac:spMkLst>
        </pc:spChg>
        <pc:spChg chg="add mod">
          <ac:chgData name="Kyuwoong Kim" userId="c6581f603476f281" providerId="LiveId" clId="{4C2B3B1C-2310-4AB4-A954-ADC28E335756}" dt="2023-12-22T02:41:32.130" v="482"/>
          <ac:spMkLst>
            <pc:docMk/>
            <pc:sldMk cId="648833912" sldId="256"/>
            <ac:spMk id="32" creationId="{4678528B-DB09-94AB-B587-41D5198D9A26}"/>
          </ac:spMkLst>
        </pc:spChg>
        <pc:spChg chg="add mod">
          <ac:chgData name="Kyuwoong Kim" userId="c6581f603476f281" providerId="LiveId" clId="{4C2B3B1C-2310-4AB4-A954-ADC28E335756}" dt="2023-12-22T02:39:40.130" v="436" actId="1076"/>
          <ac:spMkLst>
            <pc:docMk/>
            <pc:sldMk cId="648833912" sldId="256"/>
            <ac:spMk id="33" creationId="{61971DD9-EE9D-3C64-F8DD-8183D3D3456F}"/>
          </ac:spMkLst>
        </pc:spChg>
        <pc:spChg chg="add mod">
          <ac:chgData name="Kyuwoong Kim" userId="c6581f603476f281" providerId="LiveId" clId="{4C2B3B1C-2310-4AB4-A954-ADC28E335756}" dt="2023-12-22T02:40:11.026" v="459"/>
          <ac:spMkLst>
            <pc:docMk/>
            <pc:sldMk cId="648833912" sldId="256"/>
            <ac:spMk id="34" creationId="{80FA53D5-FEE6-02E5-6DE0-C9E26F2331AB}"/>
          </ac:spMkLst>
        </pc:spChg>
        <pc:spChg chg="add mod">
          <ac:chgData name="Kyuwoong Kim" userId="c6581f603476f281" providerId="LiveId" clId="{4C2B3B1C-2310-4AB4-A954-ADC28E335756}" dt="2023-12-22T02:39:40.130" v="436" actId="1076"/>
          <ac:spMkLst>
            <pc:docMk/>
            <pc:sldMk cId="648833912" sldId="256"/>
            <ac:spMk id="35" creationId="{3B5806F3-36F5-6DF5-0AF2-60DF275BB797}"/>
          </ac:spMkLst>
        </pc:spChg>
        <pc:spChg chg="add mod">
          <ac:chgData name="Kyuwoong Kim" userId="c6581f603476f281" providerId="LiveId" clId="{4C2B3B1C-2310-4AB4-A954-ADC28E335756}" dt="2023-12-22T02:41:05.901" v="477"/>
          <ac:spMkLst>
            <pc:docMk/>
            <pc:sldMk cId="648833912" sldId="256"/>
            <ac:spMk id="36" creationId="{B7EEE248-8304-9643-3D5B-3A97CA501CAE}"/>
          </ac:spMkLst>
        </pc:spChg>
        <pc:spChg chg="add mod">
          <ac:chgData name="Kyuwoong Kim" userId="c6581f603476f281" providerId="LiveId" clId="{4C2B3B1C-2310-4AB4-A954-ADC28E335756}" dt="2023-12-22T02:39:40.130" v="436" actId="1076"/>
          <ac:spMkLst>
            <pc:docMk/>
            <pc:sldMk cId="648833912" sldId="256"/>
            <ac:spMk id="37" creationId="{5179028C-B7AA-2FD1-3382-46A04DAF1845}"/>
          </ac:spMkLst>
        </pc:spChg>
        <pc:grpChg chg="add mod">
          <ac:chgData name="Kyuwoong Kim" userId="c6581f603476f281" providerId="LiveId" clId="{4C2B3B1C-2310-4AB4-A954-ADC28E335756}" dt="2023-12-22T02:39:40.130" v="436" actId="1076"/>
          <ac:grpSpMkLst>
            <pc:docMk/>
            <pc:sldMk cId="648833912" sldId="256"/>
            <ac:grpSpMk id="16" creationId="{DF6075C8-D9A8-1BA5-6729-88B15C885B2D}"/>
          </ac:grpSpMkLst>
        </pc:grpChg>
        <pc:picChg chg="add mod">
          <ac:chgData name="Kyuwoong Kim" userId="c6581f603476f281" providerId="LiveId" clId="{4C2B3B1C-2310-4AB4-A954-ADC28E335756}" dt="2023-12-26T06:19:00.434" v="563" actId="1076"/>
          <ac:picMkLst>
            <pc:docMk/>
            <pc:sldMk cId="648833912" sldId="256"/>
            <ac:picMk id="2" creationId="{A7E0DEB9-D172-D4CE-9CC1-F9C55B63D1A8}"/>
          </ac:picMkLst>
        </pc:picChg>
        <pc:picChg chg="add mod">
          <ac:chgData name="Kyuwoong Kim" userId="c6581f603476f281" providerId="LiveId" clId="{4C2B3B1C-2310-4AB4-A954-ADC28E335756}" dt="2023-12-22T02:13:03.330" v="38" actId="1076"/>
          <ac:picMkLst>
            <pc:docMk/>
            <pc:sldMk cId="648833912" sldId="256"/>
            <ac:picMk id="3" creationId="{A0A6CB00-12F0-B4E9-88A2-B06026F9DA91}"/>
          </ac:picMkLst>
        </pc:picChg>
        <pc:picChg chg="add mod">
          <ac:chgData name="Kyuwoong Kim" userId="c6581f603476f281" providerId="LiveId" clId="{4C2B3B1C-2310-4AB4-A954-ADC28E335756}" dt="2023-12-22T02:13:03.330" v="38" actId="1076"/>
          <ac:picMkLst>
            <pc:docMk/>
            <pc:sldMk cId="648833912" sldId="256"/>
            <ac:picMk id="4" creationId="{F3923BCE-31B9-CA0F-397E-B63633BEBADB}"/>
          </ac:picMkLst>
        </pc:picChg>
        <pc:picChg chg="add mod">
          <ac:chgData name="Kyuwoong Kim" userId="c6581f603476f281" providerId="LiveId" clId="{4C2B3B1C-2310-4AB4-A954-ADC28E335756}" dt="2023-12-26T06:19:09.636" v="565" actId="1076"/>
          <ac:picMkLst>
            <pc:docMk/>
            <pc:sldMk cId="648833912" sldId="256"/>
            <ac:picMk id="15" creationId="{23B2810A-7602-6CA4-4CB2-C591CF3DA2A5}"/>
          </ac:picMkLst>
        </pc:picChg>
        <pc:picChg chg="add mod">
          <ac:chgData name="Kyuwoong Kim" userId="c6581f603476f281" providerId="LiveId" clId="{4C2B3B1C-2310-4AB4-A954-ADC28E335756}" dt="2023-12-22T02:39:40.130" v="436" actId="1076"/>
          <ac:picMkLst>
            <pc:docMk/>
            <pc:sldMk cId="648833912" sldId="256"/>
            <ac:picMk id="26" creationId="{07FCE925-4484-CCCE-19AD-B78566DC0BC1}"/>
          </ac:picMkLst>
        </pc:picChg>
        <pc:picChg chg="add mod">
          <ac:chgData name="Kyuwoong Kim" userId="c6581f603476f281" providerId="LiveId" clId="{4C2B3B1C-2310-4AB4-A954-ADC28E335756}" dt="2023-12-26T06:19:03.632" v="564" actId="1076"/>
          <ac:picMkLst>
            <pc:docMk/>
            <pc:sldMk cId="648833912" sldId="256"/>
            <ac:picMk id="27" creationId="{250591F6-C4B2-33FA-F314-E5035DD94202}"/>
          </ac:picMkLst>
        </pc:picChg>
      </pc:sldChg>
      <pc:sldChg chg="del">
        <pc:chgData name="Kyuwoong Kim" userId="c6581f603476f281" providerId="LiveId" clId="{4C2B3B1C-2310-4AB4-A954-ADC28E335756}" dt="2023-12-22T02:10:32.383" v="2" actId="47"/>
        <pc:sldMkLst>
          <pc:docMk/>
          <pc:sldMk cId="3235639082" sldId="258"/>
        </pc:sldMkLst>
      </pc:sldChg>
      <pc:sldChg chg="del ord">
        <pc:chgData name="Kyuwoong Kim" userId="c6581f603476f281" providerId="LiveId" clId="{4C2B3B1C-2310-4AB4-A954-ADC28E335756}" dt="2023-12-22T02:10:32.897" v="3" actId="47"/>
        <pc:sldMkLst>
          <pc:docMk/>
          <pc:sldMk cId="1812910984" sldId="260"/>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968455" y="1797080"/>
            <a:ext cx="10975816" cy="3822924"/>
          </a:xfrm>
        </p:spPr>
        <p:txBody>
          <a:bodyPr anchor="b"/>
          <a:lstStyle>
            <a:lvl1pPr algn="ctr">
              <a:defRPr sz="8473"/>
            </a:lvl1pPr>
          </a:lstStyle>
          <a:p>
            <a:r>
              <a:rPr lang="ko-KR" altLang="en-US"/>
              <a:t>마스터 제목 스타일 편집</a:t>
            </a:r>
            <a:endParaRPr lang="en-US" dirty="0"/>
          </a:p>
        </p:txBody>
      </p:sp>
      <p:sp>
        <p:nvSpPr>
          <p:cNvPr id="3" name="Subtitle 2"/>
          <p:cNvSpPr>
            <a:spLocks noGrp="1"/>
          </p:cNvSpPr>
          <p:nvPr>
            <p:ph type="subTitle" idx="1"/>
          </p:nvPr>
        </p:nvSpPr>
        <p:spPr>
          <a:xfrm>
            <a:off x="1614091" y="5767430"/>
            <a:ext cx="9684544" cy="2651136"/>
          </a:xfrm>
        </p:spPr>
        <p:txBody>
          <a:bodyPr/>
          <a:lstStyle>
            <a:lvl1pPr marL="0" indent="0" algn="ctr">
              <a:buNone/>
              <a:defRPr sz="3389"/>
            </a:lvl1pPr>
            <a:lvl2pPr marL="645658" indent="0" algn="ctr">
              <a:buNone/>
              <a:defRPr sz="2824"/>
            </a:lvl2pPr>
            <a:lvl3pPr marL="1291316" indent="0" algn="ctr">
              <a:buNone/>
              <a:defRPr sz="2542"/>
            </a:lvl3pPr>
            <a:lvl4pPr marL="1936974" indent="0" algn="ctr">
              <a:buNone/>
              <a:defRPr sz="2260"/>
            </a:lvl4pPr>
            <a:lvl5pPr marL="2582631" indent="0" algn="ctr">
              <a:buNone/>
              <a:defRPr sz="2260"/>
            </a:lvl5pPr>
            <a:lvl6pPr marL="3228289" indent="0" algn="ctr">
              <a:buNone/>
              <a:defRPr sz="2260"/>
            </a:lvl6pPr>
            <a:lvl7pPr marL="3873947" indent="0" algn="ctr">
              <a:buNone/>
              <a:defRPr sz="2260"/>
            </a:lvl7pPr>
            <a:lvl8pPr marL="4519605" indent="0" algn="ctr">
              <a:buNone/>
              <a:defRPr sz="2260"/>
            </a:lvl8pPr>
            <a:lvl9pPr marL="5165263" indent="0" algn="ctr">
              <a:buNone/>
              <a:defRPr sz="226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35533468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28686278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240670" y="584623"/>
            <a:ext cx="2784306" cy="9305668"/>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887751" y="584623"/>
            <a:ext cx="8191510" cy="930566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41286612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33145664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881025" y="2737562"/>
            <a:ext cx="11137225" cy="4567681"/>
          </a:xfrm>
        </p:spPr>
        <p:txBody>
          <a:bodyPr anchor="b"/>
          <a:lstStyle>
            <a:lvl1pPr>
              <a:defRPr sz="8473"/>
            </a:lvl1pPr>
          </a:lstStyle>
          <a:p>
            <a:r>
              <a:rPr lang="ko-KR" altLang="en-US"/>
              <a:t>마스터 제목 스타일 편집</a:t>
            </a:r>
            <a:endParaRPr lang="en-US" dirty="0"/>
          </a:p>
        </p:txBody>
      </p:sp>
      <p:sp>
        <p:nvSpPr>
          <p:cNvPr id="3" name="Text Placeholder 2"/>
          <p:cNvSpPr>
            <a:spLocks noGrp="1"/>
          </p:cNvSpPr>
          <p:nvPr>
            <p:ph type="body" idx="1"/>
          </p:nvPr>
        </p:nvSpPr>
        <p:spPr>
          <a:xfrm>
            <a:off x="881025" y="7348455"/>
            <a:ext cx="11137225" cy="2402036"/>
          </a:xfrm>
        </p:spPr>
        <p:txBody>
          <a:bodyPr/>
          <a:lstStyle>
            <a:lvl1pPr marL="0" indent="0">
              <a:buNone/>
              <a:defRPr sz="3389">
                <a:solidFill>
                  <a:schemeClr val="tx1"/>
                </a:solidFill>
              </a:defRPr>
            </a:lvl1pPr>
            <a:lvl2pPr marL="645658" indent="0">
              <a:buNone/>
              <a:defRPr sz="2824">
                <a:solidFill>
                  <a:schemeClr val="tx1">
                    <a:tint val="75000"/>
                  </a:schemeClr>
                </a:solidFill>
              </a:defRPr>
            </a:lvl2pPr>
            <a:lvl3pPr marL="1291316" indent="0">
              <a:buNone/>
              <a:defRPr sz="2542">
                <a:solidFill>
                  <a:schemeClr val="tx1">
                    <a:tint val="75000"/>
                  </a:schemeClr>
                </a:solidFill>
              </a:defRPr>
            </a:lvl3pPr>
            <a:lvl4pPr marL="1936974" indent="0">
              <a:buNone/>
              <a:defRPr sz="2260">
                <a:solidFill>
                  <a:schemeClr val="tx1">
                    <a:tint val="75000"/>
                  </a:schemeClr>
                </a:solidFill>
              </a:defRPr>
            </a:lvl4pPr>
            <a:lvl5pPr marL="2582631" indent="0">
              <a:buNone/>
              <a:defRPr sz="2260">
                <a:solidFill>
                  <a:schemeClr val="tx1">
                    <a:tint val="75000"/>
                  </a:schemeClr>
                </a:solidFill>
              </a:defRPr>
            </a:lvl5pPr>
            <a:lvl6pPr marL="3228289" indent="0">
              <a:buNone/>
              <a:defRPr sz="2260">
                <a:solidFill>
                  <a:schemeClr val="tx1">
                    <a:tint val="75000"/>
                  </a:schemeClr>
                </a:solidFill>
              </a:defRPr>
            </a:lvl6pPr>
            <a:lvl7pPr marL="3873947" indent="0">
              <a:buNone/>
              <a:defRPr sz="2260">
                <a:solidFill>
                  <a:schemeClr val="tx1">
                    <a:tint val="75000"/>
                  </a:schemeClr>
                </a:solidFill>
              </a:defRPr>
            </a:lvl7pPr>
            <a:lvl8pPr marL="4519605" indent="0">
              <a:buNone/>
              <a:defRPr sz="2260">
                <a:solidFill>
                  <a:schemeClr val="tx1">
                    <a:tint val="75000"/>
                  </a:schemeClr>
                </a:solidFill>
              </a:defRPr>
            </a:lvl8pPr>
            <a:lvl9pPr marL="5165263" indent="0">
              <a:buNone/>
              <a:defRPr sz="226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20065696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887750" y="2923113"/>
            <a:ext cx="5487908" cy="6967177"/>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6537067" y="2923113"/>
            <a:ext cx="5487908" cy="6967177"/>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22749827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889432" y="584625"/>
            <a:ext cx="11137225" cy="2122435"/>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889433" y="2691807"/>
            <a:ext cx="5462687" cy="1319213"/>
          </a:xfrm>
        </p:spPr>
        <p:txBody>
          <a:bodyPr anchor="b"/>
          <a:lstStyle>
            <a:lvl1pPr marL="0" indent="0">
              <a:buNone/>
              <a:defRPr sz="3389" b="1"/>
            </a:lvl1pPr>
            <a:lvl2pPr marL="645658" indent="0">
              <a:buNone/>
              <a:defRPr sz="2824" b="1"/>
            </a:lvl2pPr>
            <a:lvl3pPr marL="1291316" indent="0">
              <a:buNone/>
              <a:defRPr sz="2542" b="1"/>
            </a:lvl3pPr>
            <a:lvl4pPr marL="1936974" indent="0">
              <a:buNone/>
              <a:defRPr sz="2260" b="1"/>
            </a:lvl4pPr>
            <a:lvl5pPr marL="2582631" indent="0">
              <a:buNone/>
              <a:defRPr sz="2260" b="1"/>
            </a:lvl5pPr>
            <a:lvl6pPr marL="3228289" indent="0">
              <a:buNone/>
              <a:defRPr sz="2260" b="1"/>
            </a:lvl6pPr>
            <a:lvl7pPr marL="3873947" indent="0">
              <a:buNone/>
              <a:defRPr sz="2260" b="1"/>
            </a:lvl7pPr>
            <a:lvl8pPr marL="4519605" indent="0">
              <a:buNone/>
              <a:defRPr sz="2260" b="1"/>
            </a:lvl8pPr>
            <a:lvl9pPr marL="5165263" indent="0">
              <a:buNone/>
              <a:defRPr sz="226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889433" y="4011019"/>
            <a:ext cx="5462687" cy="589960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6537068" y="2691807"/>
            <a:ext cx="5489590" cy="1319213"/>
          </a:xfrm>
        </p:spPr>
        <p:txBody>
          <a:bodyPr anchor="b"/>
          <a:lstStyle>
            <a:lvl1pPr marL="0" indent="0">
              <a:buNone/>
              <a:defRPr sz="3389" b="1"/>
            </a:lvl1pPr>
            <a:lvl2pPr marL="645658" indent="0">
              <a:buNone/>
              <a:defRPr sz="2824" b="1"/>
            </a:lvl2pPr>
            <a:lvl3pPr marL="1291316" indent="0">
              <a:buNone/>
              <a:defRPr sz="2542" b="1"/>
            </a:lvl3pPr>
            <a:lvl4pPr marL="1936974" indent="0">
              <a:buNone/>
              <a:defRPr sz="2260" b="1"/>
            </a:lvl4pPr>
            <a:lvl5pPr marL="2582631" indent="0">
              <a:buNone/>
              <a:defRPr sz="2260" b="1"/>
            </a:lvl5pPr>
            <a:lvl6pPr marL="3228289" indent="0">
              <a:buNone/>
              <a:defRPr sz="2260" b="1"/>
            </a:lvl6pPr>
            <a:lvl7pPr marL="3873947" indent="0">
              <a:buNone/>
              <a:defRPr sz="2260" b="1"/>
            </a:lvl7pPr>
            <a:lvl8pPr marL="4519605" indent="0">
              <a:buNone/>
              <a:defRPr sz="2260" b="1"/>
            </a:lvl8pPr>
            <a:lvl9pPr marL="5165263" indent="0">
              <a:buNone/>
              <a:defRPr sz="226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6537068" y="4011019"/>
            <a:ext cx="5489590" cy="589960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7851294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33861853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40237812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889432" y="732049"/>
            <a:ext cx="4164690" cy="2562172"/>
          </a:xfrm>
        </p:spPr>
        <p:txBody>
          <a:bodyPr anchor="b"/>
          <a:lstStyle>
            <a:lvl1pPr>
              <a:defRPr sz="4519"/>
            </a:lvl1pPr>
          </a:lstStyle>
          <a:p>
            <a:r>
              <a:rPr lang="ko-KR" altLang="en-US"/>
              <a:t>마스터 제목 스타일 편집</a:t>
            </a:r>
            <a:endParaRPr lang="en-US" dirty="0"/>
          </a:p>
        </p:txBody>
      </p:sp>
      <p:sp>
        <p:nvSpPr>
          <p:cNvPr id="3" name="Content Placeholder 2"/>
          <p:cNvSpPr>
            <a:spLocks noGrp="1"/>
          </p:cNvSpPr>
          <p:nvPr>
            <p:ph idx="1"/>
          </p:nvPr>
        </p:nvSpPr>
        <p:spPr>
          <a:xfrm>
            <a:off x="5489590" y="1581025"/>
            <a:ext cx="6537067" cy="7803441"/>
          </a:xfrm>
        </p:spPr>
        <p:txBody>
          <a:bodyPr/>
          <a:lstStyle>
            <a:lvl1pPr>
              <a:defRPr sz="4519"/>
            </a:lvl1pPr>
            <a:lvl2pPr>
              <a:defRPr sz="3954"/>
            </a:lvl2pPr>
            <a:lvl3pPr>
              <a:defRPr sz="3389"/>
            </a:lvl3pPr>
            <a:lvl4pPr>
              <a:defRPr sz="2824"/>
            </a:lvl4pPr>
            <a:lvl5pPr>
              <a:defRPr sz="2824"/>
            </a:lvl5pPr>
            <a:lvl6pPr>
              <a:defRPr sz="2824"/>
            </a:lvl6pPr>
            <a:lvl7pPr>
              <a:defRPr sz="2824"/>
            </a:lvl7pPr>
            <a:lvl8pPr>
              <a:defRPr sz="2824"/>
            </a:lvl8pPr>
            <a:lvl9pPr>
              <a:defRPr sz="2824"/>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889432" y="3294221"/>
            <a:ext cx="4164690" cy="6102953"/>
          </a:xfrm>
        </p:spPr>
        <p:txBody>
          <a:bodyPr/>
          <a:lstStyle>
            <a:lvl1pPr marL="0" indent="0">
              <a:buNone/>
              <a:defRPr sz="2260"/>
            </a:lvl1pPr>
            <a:lvl2pPr marL="645658" indent="0">
              <a:buNone/>
              <a:defRPr sz="1977"/>
            </a:lvl2pPr>
            <a:lvl3pPr marL="1291316" indent="0">
              <a:buNone/>
              <a:defRPr sz="1695"/>
            </a:lvl3pPr>
            <a:lvl4pPr marL="1936974" indent="0">
              <a:buNone/>
              <a:defRPr sz="1412"/>
            </a:lvl4pPr>
            <a:lvl5pPr marL="2582631" indent="0">
              <a:buNone/>
              <a:defRPr sz="1412"/>
            </a:lvl5pPr>
            <a:lvl6pPr marL="3228289" indent="0">
              <a:buNone/>
              <a:defRPr sz="1412"/>
            </a:lvl6pPr>
            <a:lvl7pPr marL="3873947" indent="0">
              <a:buNone/>
              <a:defRPr sz="1412"/>
            </a:lvl7pPr>
            <a:lvl8pPr marL="4519605" indent="0">
              <a:buNone/>
              <a:defRPr sz="1412"/>
            </a:lvl8pPr>
            <a:lvl9pPr marL="5165263" indent="0">
              <a:buNone/>
              <a:defRPr sz="1412"/>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4250881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889432" y="732049"/>
            <a:ext cx="4164690" cy="2562172"/>
          </a:xfrm>
        </p:spPr>
        <p:txBody>
          <a:bodyPr anchor="b"/>
          <a:lstStyle>
            <a:lvl1pPr>
              <a:defRPr sz="4519"/>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5489590" y="1581025"/>
            <a:ext cx="6537067" cy="7803441"/>
          </a:xfrm>
        </p:spPr>
        <p:txBody>
          <a:bodyPr anchor="t"/>
          <a:lstStyle>
            <a:lvl1pPr marL="0" indent="0">
              <a:buNone/>
              <a:defRPr sz="4519"/>
            </a:lvl1pPr>
            <a:lvl2pPr marL="645658" indent="0">
              <a:buNone/>
              <a:defRPr sz="3954"/>
            </a:lvl2pPr>
            <a:lvl3pPr marL="1291316" indent="0">
              <a:buNone/>
              <a:defRPr sz="3389"/>
            </a:lvl3pPr>
            <a:lvl4pPr marL="1936974" indent="0">
              <a:buNone/>
              <a:defRPr sz="2824"/>
            </a:lvl4pPr>
            <a:lvl5pPr marL="2582631" indent="0">
              <a:buNone/>
              <a:defRPr sz="2824"/>
            </a:lvl5pPr>
            <a:lvl6pPr marL="3228289" indent="0">
              <a:buNone/>
              <a:defRPr sz="2824"/>
            </a:lvl6pPr>
            <a:lvl7pPr marL="3873947" indent="0">
              <a:buNone/>
              <a:defRPr sz="2824"/>
            </a:lvl7pPr>
            <a:lvl8pPr marL="4519605" indent="0">
              <a:buNone/>
              <a:defRPr sz="2824"/>
            </a:lvl8pPr>
            <a:lvl9pPr marL="5165263" indent="0">
              <a:buNone/>
              <a:defRPr sz="2824"/>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889432" y="3294221"/>
            <a:ext cx="4164690" cy="6102953"/>
          </a:xfrm>
        </p:spPr>
        <p:txBody>
          <a:bodyPr/>
          <a:lstStyle>
            <a:lvl1pPr marL="0" indent="0">
              <a:buNone/>
              <a:defRPr sz="2260"/>
            </a:lvl1pPr>
            <a:lvl2pPr marL="645658" indent="0">
              <a:buNone/>
              <a:defRPr sz="1977"/>
            </a:lvl2pPr>
            <a:lvl3pPr marL="1291316" indent="0">
              <a:buNone/>
              <a:defRPr sz="1695"/>
            </a:lvl3pPr>
            <a:lvl4pPr marL="1936974" indent="0">
              <a:buNone/>
              <a:defRPr sz="1412"/>
            </a:lvl4pPr>
            <a:lvl5pPr marL="2582631" indent="0">
              <a:buNone/>
              <a:defRPr sz="1412"/>
            </a:lvl5pPr>
            <a:lvl6pPr marL="3228289" indent="0">
              <a:buNone/>
              <a:defRPr sz="1412"/>
            </a:lvl6pPr>
            <a:lvl7pPr marL="3873947" indent="0">
              <a:buNone/>
              <a:defRPr sz="1412"/>
            </a:lvl7pPr>
            <a:lvl8pPr marL="4519605" indent="0">
              <a:buNone/>
              <a:defRPr sz="1412"/>
            </a:lvl8pPr>
            <a:lvl9pPr marL="5165263" indent="0">
              <a:buNone/>
              <a:defRPr sz="1412"/>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25B07CCA-649A-4FD3-AAA7-E4EFBF2F110A}" type="datetimeFigureOut">
              <a:rPr lang="ko-KR" altLang="en-US" smtClean="0"/>
              <a:t>2023-12-27</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13613861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87750" y="584625"/>
            <a:ext cx="11137225" cy="2122435"/>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887750" y="2923113"/>
            <a:ext cx="11137225" cy="6967177"/>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887750" y="10177520"/>
            <a:ext cx="2905363" cy="584623"/>
          </a:xfrm>
          <a:prstGeom prst="rect">
            <a:avLst/>
          </a:prstGeom>
        </p:spPr>
        <p:txBody>
          <a:bodyPr vert="horz" lIns="91440" tIns="45720" rIns="91440" bIns="45720" rtlCol="0" anchor="ctr"/>
          <a:lstStyle>
            <a:lvl1pPr algn="l">
              <a:defRPr sz="1695">
                <a:solidFill>
                  <a:schemeClr val="tx1">
                    <a:tint val="75000"/>
                  </a:schemeClr>
                </a:solidFill>
              </a:defRPr>
            </a:lvl1pPr>
          </a:lstStyle>
          <a:p>
            <a:fld id="{25B07CCA-649A-4FD3-AAA7-E4EFBF2F110A}" type="datetimeFigureOut">
              <a:rPr lang="ko-KR" altLang="en-US" smtClean="0"/>
              <a:t>2023-12-27</a:t>
            </a:fld>
            <a:endParaRPr lang="ko-KR" altLang="en-US"/>
          </a:p>
        </p:txBody>
      </p:sp>
      <p:sp>
        <p:nvSpPr>
          <p:cNvPr id="5" name="Footer Placeholder 4"/>
          <p:cNvSpPr>
            <a:spLocks noGrp="1"/>
          </p:cNvSpPr>
          <p:nvPr>
            <p:ph type="ftr" sz="quarter" idx="3"/>
          </p:nvPr>
        </p:nvSpPr>
        <p:spPr>
          <a:xfrm>
            <a:off x="4277340" y="10177520"/>
            <a:ext cx="4358045" cy="584623"/>
          </a:xfrm>
          <a:prstGeom prst="rect">
            <a:avLst/>
          </a:prstGeom>
        </p:spPr>
        <p:txBody>
          <a:bodyPr vert="horz" lIns="91440" tIns="45720" rIns="91440" bIns="45720" rtlCol="0" anchor="ctr"/>
          <a:lstStyle>
            <a:lvl1pPr algn="ctr">
              <a:defRPr sz="1695">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9119612" y="10177520"/>
            <a:ext cx="2905363" cy="584623"/>
          </a:xfrm>
          <a:prstGeom prst="rect">
            <a:avLst/>
          </a:prstGeom>
        </p:spPr>
        <p:txBody>
          <a:bodyPr vert="horz" lIns="91440" tIns="45720" rIns="91440" bIns="45720" rtlCol="0" anchor="ctr"/>
          <a:lstStyle>
            <a:lvl1pPr algn="r">
              <a:defRPr sz="1695">
                <a:solidFill>
                  <a:schemeClr val="tx1">
                    <a:tint val="75000"/>
                  </a:schemeClr>
                </a:solidFill>
              </a:defRPr>
            </a:lvl1pPr>
          </a:lstStyle>
          <a:p>
            <a:fld id="{7FC25BD4-207C-4562-8817-4E800C9CADB5}" type="slidenum">
              <a:rPr lang="ko-KR" altLang="en-US" smtClean="0"/>
              <a:t>‹#›</a:t>
            </a:fld>
            <a:endParaRPr lang="ko-KR" altLang="en-US"/>
          </a:p>
        </p:txBody>
      </p:sp>
    </p:spTree>
    <p:extLst>
      <p:ext uri="{BB962C8B-B14F-4D97-AF65-F5344CB8AC3E}">
        <p14:creationId xmlns:p14="http://schemas.microsoft.com/office/powerpoint/2010/main" val="982717503"/>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91316" rtl="0" eaLnBrk="1" latinLnBrk="1" hangingPunct="1">
        <a:lnSpc>
          <a:spcPct val="90000"/>
        </a:lnSpc>
        <a:spcBef>
          <a:spcPct val="0"/>
        </a:spcBef>
        <a:buNone/>
        <a:defRPr sz="6214" kern="1200">
          <a:solidFill>
            <a:schemeClr val="tx1"/>
          </a:solidFill>
          <a:latin typeface="+mj-lt"/>
          <a:ea typeface="+mj-ea"/>
          <a:cs typeface="+mj-cs"/>
        </a:defRPr>
      </a:lvl1pPr>
    </p:titleStyle>
    <p:bodyStyle>
      <a:lvl1pPr marL="322829" indent="-322829" algn="l" defTabSz="1291316" rtl="0" eaLnBrk="1" latinLnBrk="1" hangingPunct="1">
        <a:lnSpc>
          <a:spcPct val="90000"/>
        </a:lnSpc>
        <a:spcBef>
          <a:spcPts val="1412"/>
        </a:spcBef>
        <a:buFont typeface="Arial" panose="020B0604020202020204" pitchFamily="34" charset="0"/>
        <a:buChar char="•"/>
        <a:defRPr sz="3954" kern="1200">
          <a:solidFill>
            <a:schemeClr val="tx1"/>
          </a:solidFill>
          <a:latin typeface="+mn-lt"/>
          <a:ea typeface="+mn-ea"/>
          <a:cs typeface="+mn-cs"/>
        </a:defRPr>
      </a:lvl1pPr>
      <a:lvl2pPr marL="968487" indent="-322829" algn="l" defTabSz="1291316" rtl="0" eaLnBrk="1" latinLnBrk="1" hangingPunct="1">
        <a:lnSpc>
          <a:spcPct val="90000"/>
        </a:lnSpc>
        <a:spcBef>
          <a:spcPts val="706"/>
        </a:spcBef>
        <a:buFont typeface="Arial" panose="020B0604020202020204" pitchFamily="34" charset="0"/>
        <a:buChar char="•"/>
        <a:defRPr sz="3389" kern="1200">
          <a:solidFill>
            <a:schemeClr val="tx1"/>
          </a:solidFill>
          <a:latin typeface="+mn-lt"/>
          <a:ea typeface="+mn-ea"/>
          <a:cs typeface="+mn-cs"/>
        </a:defRPr>
      </a:lvl2pPr>
      <a:lvl3pPr marL="1614145" indent="-322829" algn="l" defTabSz="1291316" rtl="0" eaLnBrk="1" latinLnBrk="1" hangingPunct="1">
        <a:lnSpc>
          <a:spcPct val="90000"/>
        </a:lnSpc>
        <a:spcBef>
          <a:spcPts val="706"/>
        </a:spcBef>
        <a:buFont typeface="Arial" panose="020B0604020202020204" pitchFamily="34" charset="0"/>
        <a:buChar char="•"/>
        <a:defRPr sz="2824" kern="1200">
          <a:solidFill>
            <a:schemeClr val="tx1"/>
          </a:solidFill>
          <a:latin typeface="+mn-lt"/>
          <a:ea typeface="+mn-ea"/>
          <a:cs typeface="+mn-cs"/>
        </a:defRPr>
      </a:lvl3pPr>
      <a:lvl4pPr marL="2259802" indent="-322829" algn="l" defTabSz="1291316" rtl="0" eaLnBrk="1" latinLnBrk="1" hangingPunct="1">
        <a:lnSpc>
          <a:spcPct val="90000"/>
        </a:lnSpc>
        <a:spcBef>
          <a:spcPts val="706"/>
        </a:spcBef>
        <a:buFont typeface="Arial" panose="020B0604020202020204" pitchFamily="34" charset="0"/>
        <a:buChar char="•"/>
        <a:defRPr sz="2542" kern="1200">
          <a:solidFill>
            <a:schemeClr val="tx1"/>
          </a:solidFill>
          <a:latin typeface="+mn-lt"/>
          <a:ea typeface="+mn-ea"/>
          <a:cs typeface="+mn-cs"/>
        </a:defRPr>
      </a:lvl4pPr>
      <a:lvl5pPr marL="2905460" indent="-322829" algn="l" defTabSz="1291316" rtl="0" eaLnBrk="1" latinLnBrk="1" hangingPunct="1">
        <a:lnSpc>
          <a:spcPct val="90000"/>
        </a:lnSpc>
        <a:spcBef>
          <a:spcPts val="706"/>
        </a:spcBef>
        <a:buFont typeface="Arial" panose="020B0604020202020204" pitchFamily="34" charset="0"/>
        <a:buChar char="•"/>
        <a:defRPr sz="2542" kern="1200">
          <a:solidFill>
            <a:schemeClr val="tx1"/>
          </a:solidFill>
          <a:latin typeface="+mn-lt"/>
          <a:ea typeface="+mn-ea"/>
          <a:cs typeface="+mn-cs"/>
        </a:defRPr>
      </a:lvl5pPr>
      <a:lvl6pPr marL="3551118" indent="-322829" algn="l" defTabSz="1291316" rtl="0" eaLnBrk="1" latinLnBrk="1" hangingPunct="1">
        <a:lnSpc>
          <a:spcPct val="90000"/>
        </a:lnSpc>
        <a:spcBef>
          <a:spcPts val="706"/>
        </a:spcBef>
        <a:buFont typeface="Arial" panose="020B0604020202020204" pitchFamily="34" charset="0"/>
        <a:buChar char="•"/>
        <a:defRPr sz="2542" kern="1200">
          <a:solidFill>
            <a:schemeClr val="tx1"/>
          </a:solidFill>
          <a:latin typeface="+mn-lt"/>
          <a:ea typeface="+mn-ea"/>
          <a:cs typeface="+mn-cs"/>
        </a:defRPr>
      </a:lvl6pPr>
      <a:lvl7pPr marL="4196776" indent="-322829" algn="l" defTabSz="1291316" rtl="0" eaLnBrk="1" latinLnBrk="1" hangingPunct="1">
        <a:lnSpc>
          <a:spcPct val="90000"/>
        </a:lnSpc>
        <a:spcBef>
          <a:spcPts val="706"/>
        </a:spcBef>
        <a:buFont typeface="Arial" panose="020B0604020202020204" pitchFamily="34" charset="0"/>
        <a:buChar char="•"/>
        <a:defRPr sz="2542" kern="1200">
          <a:solidFill>
            <a:schemeClr val="tx1"/>
          </a:solidFill>
          <a:latin typeface="+mn-lt"/>
          <a:ea typeface="+mn-ea"/>
          <a:cs typeface="+mn-cs"/>
        </a:defRPr>
      </a:lvl7pPr>
      <a:lvl8pPr marL="4842434" indent="-322829" algn="l" defTabSz="1291316" rtl="0" eaLnBrk="1" latinLnBrk="1" hangingPunct="1">
        <a:lnSpc>
          <a:spcPct val="90000"/>
        </a:lnSpc>
        <a:spcBef>
          <a:spcPts val="706"/>
        </a:spcBef>
        <a:buFont typeface="Arial" panose="020B0604020202020204" pitchFamily="34" charset="0"/>
        <a:buChar char="•"/>
        <a:defRPr sz="2542" kern="1200">
          <a:solidFill>
            <a:schemeClr val="tx1"/>
          </a:solidFill>
          <a:latin typeface="+mn-lt"/>
          <a:ea typeface="+mn-ea"/>
          <a:cs typeface="+mn-cs"/>
        </a:defRPr>
      </a:lvl8pPr>
      <a:lvl9pPr marL="5488092" indent="-322829" algn="l" defTabSz="1291316" rtl="0" eaLnBrk="1" latinLnBrk="1" hangingPunct="1">
        <a:lnSpc>
          <a:spcPct val="90000"/>
        </a:lnSpc>
        <a:spcBef>
          <a:spcPts val="706"/>
        </a:spcBef>
        <a:buFont typeface="Arial" panose="020B0604020202020204" pitchFamily="34" charset="0"/>
        <a:buChar char="•"/>
        <a:defRPr sz="2542" kern="1200">
          <a:solidFill>
            <a:schemeClr val="tx1"/>
          </a:solidFill>
          <a:latin typeface="+mn-lt"/>
          <a:ea typeface="+mn-ea"/>
          <a:cs typeface="+mn-cs"/>
        </a:defRPr>
      </a:lvl9pPr>
    </p:bodyStyle>
    <p:otherStyle>
      <a:defPPr>
        <a:defRPr lang="en-US"/>
      </a:defPPr>
      <a:lvl1pPr marL="0" algn="l" defTabSz="1291316" rtl="0" eaLnBrk="1" latinLnBrk="1" hangingPunct="1">
        <a:defRPr sz="2542" kern="1200">
          <a:solidFill>
            <a:schemeClr val="tx1"/>
          </a:solidFill>
          <a:latin typeface="+mn-lt"/>
          <a:ea typeface="+mn-ea"/>
          <a:cs typeface="+mn-cs"/>
        </a:defRPr>
      </a:lvl1pPr>
      <a:lvl2pPr marL="645658" algn="l" defTabSz="1291316" rtl="0" eaLnBrk="1" latinLnBrk="1" hangingPunct="1">
        <a:defRPr sz="2542" kern="1200">
          <a:solidFill>
            <a:schemeClr val="tx1"/>
          </a:solidFill>
          <a:latin typeface="+mn-lt"/>
          <a:ea typeface="+mn-ea"/>
          <a:cs typeface="+mn-cs"/>
        </a:defRPr>
      </a:lvl2pPr>
      <a:lvl3pPr marL="1291316" algn="l" defTabSz="1291316" rtl="0" eaLnBrk="1" latinLnBrk="1" hangingPunct="1">
        <a:defRPr sz="2542" kern="1200">
          <a:solidFill>
            <a:schemeClr val="tx1"/>
          </a:solidFill>
          <a:latin typeface="+mn-lt"/>
          <a:ea typeface="+mn-ea"/>
          <a:cs typeface="+mn-cs"/>
        </a:defRPr>
      </a:lvl3pPr>
      <a:lvl4pPr marL="1936974" algn="l" defTabSz="1291316" rtl="0" eaLnBrk="1" latinLnBrk="1" hangingPunct="1">
        <a:defRPr sz="2542" kern="1200">
          <a:solidFill>
            <a:schemeClr val="tx1"/>
          </a:solidFill>
          <a:latin typeface="+mn-lt"/>
          <a:ea typeface="+mn-ea"/>
          <a:cs typeface="+mn-cs"/>
        </a:defRPr>
      </a:lvl4pPr>
      <a:lvl5pPr marL="2582631" algn="l" defTabSz="1291316" rtl="0" eaLnBrk="1" latinLnBrk="1" hangingPunct="1">
        <a:defRPr sz="2542" kern="1200">
          <a:solidFill>
            <a:schemeClr val="tx1"/>
          </a:solidFill>
          <a:latin typeface="+mn-lt"/>
          <a:ea typeface="+mn-ea"/>
          <a:cs typeface="+mn-cs"/>
        </a:defRPr>
      </a:lvl5pPr>
      <a:lvl6pPr marL="3228289" algn="l" defTabSz="1291316" rtl="0" eaLnBrk="1" latinLnBrk="1" hangingPunct="1">
        <a:defRPr sz="2542" kern="1200">
          <a:solidFill>
            <a:schemeClr val="tx1"/>
          </a:solidFill>
          <a:latin typeface="+mn-lt"/>
          <a:ea typeface="+mn-ea"/>
          <a:cs typeface="+mn-cs"/>
        </a:defRPr>
      </a:lvl6pPr>
      <a:lvl7pPr marL="3873947" algn="l" defTabSz="1291316" rtl="0" eaLnBrk="1" latinLnBrk="1" hangingPunct="1">
        <a:defRPr sz="2542" kern="1200">
          <a:solidFill>
            <a:schemeClr val="tx1"/>
          </a:solidFill>
          <a:latin typeface="+mn-lt"/>
          <a:ea typeface="+mn-ea"/>
          <a:cs typeface="+mn-cs"/>
        </a:defRPr>
      </a:lvl7pPr>
      <a:lvl8pPr marL="4519605" algn="l" defTabSz="1291316" rtl="0" eaLnBrk="1" latinLnBrk="1" hangingPunct="1">
        <a:defRPr sz="2542" kern="1200">
          <a:solidFill>
            <a:schemeClr val="tx1"/>
          </a:solidFill>
          <a:latin typeface="+mn-lt"/>
          <a:ea typeface="+mn-ea"/>
          <a:cs typeface="+mn-cs"/>
        </a:defRPr>
      </a:lvl8pPr>
      <a:lvl9pPr marL="5165263" algn="l" defTabSz="1291316" rtl="0" eaLnBrk="1" latinLnBrk="1" hangingPunct="1">
        <a:defRPr sz="254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그림 5" descr="텍스트, 스크린샷, 도표, 라인이(가) 표시된 사진&#10;&#10;자동 생성된 설명">
            <a:extLst>
              <a:ext uri="{FF2B5EF4-FFF2-40B4-BE49-F238E27FC236}">
                <a16:creationId xmlns:a16="http://schemas.microsoft.com/office/drawing/2014/main" id="{2E0E3B99-2D8A-1654-1D9E-E8E5DC6EE45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687043" y="2188757"/>
            <a:ext cx="3492133" cy="3354405"/>
          </a:xfrm>
          <a:prstGeom prst="rect">
            <a:avLst/>
          </a:prstGeom>
        </p:spPr>
      </p:pic>
      <p:pic>
        <p:nvPicPr>
          <p:cNvPr id="7" name="그림 6" descr="텍스트, 스크린샷, 도표이(가) 표시된 사진&#10;&#10;자동 생성된 설명">
            <a:extLst>
              <a:ext uri="{FF2B5EF4-FFF2-40B4-BE49-F238E27FC236}">
                <a16:creationId xmlns:a16="http://schemas.microsoft.com/office/drawing/2014/main" id="{6EC75941-0253-1363-18C9-092E3CF758D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683780" y="2436059"/>
            <a:ext cx="3724643" cy="3107103"/>
          </a:xfrm>
          <a:prstGeom prst="rect">
            <a:avLst/>
          </a:prstGeom>
        </p:spPr>
      </p:pic>
      <p:sp>
        <p:nvSpPr>
          <p:cNvPr id="38" name="TextBox 37">
            <a:extLst>
              <a:ext uri="{FF2B5EF4-FFF2-40B4-BE49-F238E27FC236}">
                <a16:creationId xmlns:a16="http://schemas.microsoft.com/office/drawing/2014/main" id="{549A40D2-B161-41AC-AD42-9BBE11DBEF59}"/>
              </a:ext>
            </a:extLst>
          </p:cNvPr>
          <p:cNvSpPr txBox="1"/>
          <p:nvPr/>
        </p:nvSpPr>
        <p:spPr>
          <a:xfrm>
            <a:off x="802584" y="1015441"/>
            <a:ext cx="3446023" cy="1508105"/>
          </a:xfrm>
          <a:prstGeom prst="rect">
            <a:avLst/>
          </a:prstGeom>
          <a:noFill/>
        </p:spPr>
        <p:txBody>
          <a:bodyPr wrap="square" rtlCol="0">
            <a:spAutoFit/>
          </a:bodyPr>
          <a:lstStyle/>
          <a:p>
            <a:pPr marL="342900" indent="-342900">
              <a:buAutoNum type="alphaUcParenBoth"/>
            </a:pPr>
            <a:r>
              <a:rPr lang="en-US" altLang="ko-KR" b="1" dirty="0"/>
              <a:t>Agreement between actual </a:t>
            </a:r>
          </a:p>
          <a:p>
            <a:r>
              <a:rPr lang="en-US" altLang="ko-KR" b="1" dirty="0"/>
              <a:t>    and predicted TFM (Total)</a:t>
            </a:r>
          </a:p>
          <a:p>
            <a:pPr algn="ctr"/>
            <a:r>
              <a:rPr lang="en-US" altLang="ko-KR" sz="1400" dirty="0"/>
              <a:t>Mean difference:  0.229</a:t>
            </a:r>
          </a:p>
          <a:p>
            <a:pPr algn="ctr"/>
            <a:r>
              <a:rPr lang="en-US" altLang="ko-KR" sz="1400" dirty="0"/>
              <a:t>95% limits of agreement: -3.571 to  4.028</a:t>
            </a:r>
          </a:p>
          <a:p>
            <a:pPr algn="ctr"/>
            <a:endParaRPr lang="en-US" altLang="ko-KR" sz="1400" dirty="0"/>
          </a:p>
          <a:p>
            <a:pPr algn="ctr"/>
            <a:r>
              <a:rPr lang="en-US" altLang="ko-KR" sz="1400" dirty="0"/>
              <a:t> </a:t>
            </a:r>
            <a:endParaRPr lang="ko-KR" altLang="en-US" sz="1400" dirty="0"/>
          </a:p>
        </p:txBody>
      </p:sp>
      <p:sp>
        <p:nvSpPr>
          <p:cNvPr id="39" name="TextBox 38">
            <a:extLst>
              <a:ext uri="{FF2B5EF4-FFF2-40B4-BE49-F238E27FC236}">
                <a16:creationId xmlns:a16="http://schemas.microsoft.com/office/drawing/2014/main" id="{0C2D4290-83CA-546A-268C-60FFDCA6B305}"/>
              </a:ext>
            </a:extLst>
          </p:cNvPr>
          <p:cNvSpPr txBox="1"/>
          <p:nvPr/>
        </p:nvSpPr>
        <p:spPr>
          <a:xfrm>
            <a:off x="4962400" y="998519"/>
            <a:ext cx="3446023" cy="1569660"/>
          </a:xfrm>
          <a:prstGeom prst="rect">
            <a:avLst/>
          </a:prstGeom>
          <a:noFill/>
        </p:spPr>
        <p:txBody>
          <a:bodyPr wrap="square" rtlCol="0">
            <a:spAutoFit/>
          </a:bodyPr>
          <a:lstStyle/>
          <a:p>
            <a:r>
              <a:rPr lang="en-US" altLang="ko-KR" b="1" dirty="0"/>
              <a:t>(B) Agreement between actual </a:t>
            </a:r>
          </a:p>
          <a:p>
            <a:r>
              <a:rPr lang="en-US" altLang="ko-KR" b="1" dirty="0"/>
              <a:t>    and predicted TFM (Men)</a:t>
            </a:r>
          </a:p>
          <a:p>
            <a:pPr algn="ctr"/>
            <a:r>
              <a:rPr lang="en-US" altLang="ko-KR" sz="1400" dirty="0"/>
              <a:t>Mean difference: 0.380</a:t>
            </a:r>
          </a:p>
          <a:p>
            <a:pPr algn="ctr"/>
            <a:r>
              <a:rPr lang="en-US" altLang="ko-KR" sz="1400" dirty="0"/>
              <a:t>95% limits of agreement: -3.624 to 4.385</a:t>
            </a:r>
          </a:p>
          <a:p>
            <a:pPr algn="ctr"/>
            <a:r>
              <a:rPr lang="en-US" altLang="ko-KR" sz="1400" dirty="0"/>
              <a:t> </a:t>
            </a:r>
            <a:endParaRPr lang="ko-KR" altLang="en-US" sz="1400" dirty="0"/>
          </a:p>
          <a:p>
            <a:r>
              <a:rPr lang="en-US" altLang="ko-KR" dirty="0"/>
              <a:t> </a:t>
            </a:r>
            <a:endParaRPr lang="ko-KR" altLang="en-US" dirty="0"/>
          </a:p>
        </p:txBody>
      </p:sp>
      <p:sp>
        <p:nvSpPr>
          <p:cNvPr id="40" name="TextBox 39">
            <a:extLst>
              <a:ext uri="{FF2B5EF4-FFF2-40B4-BE49-F238E27FC236}">
                <a16:creationId xmlns:a16="http://schemas.microsoft.com/office/drawing/2014/main" id="{90309B63-1CFE-2EFE-B9B5-8D7A365C6ACC}"/>
              </a:ext>
            </a:extLst>
          </p:cNvPr>
          <p:cNvSpPr txBox="1"/>
          <p:nvPr/>
        </p:nvSpPr>
        <p:spPr>
          <a:xfrm>
            <a:off x="8759907" y="999757"/>
            <a:ext cx="3610045" cy="1569660"/>
          </a:xfrm>
          <a:prstGeom prst="rect">
            <a:avLst/>
          </a:prstGeom>
          <a:noFill/>
        </p:spPr>
        <p:txBody>
          <a:bodyPr wrap="square" rtlCol="0">
            <a:spAutoFit/>
          </a:bodyPr>
          <a:lstStyle/>
          <a:p>
            <a:r>
              <a:rPr lang="en-US" altLang="ko-KR" b="1" dirty="0"/>
              <a:t>   (C) Agreement between actual </a:t>
            </a:r>
          </a:p>
          <a:p>
            <a:r>
              <a:rPr lang="en-US" altLang="ko-KR" b="1" dirty="0"/>
              <a:t>      and predicted TFM (Women)</a:t>
            </a:r>
          </a:p>
          <a:p>
            <a:pPr algn="ctr"/>
            <a:r>
              <a:rPr lang="en-US" altLang="ko-KR" sz="1400" dirty="0"/>
              <a:t>Mean difference: 0.174</a:t>
            </a:r>
          </a:p>
          <a:p>
            <a:pPr algn="ctr"/>
            <a:r>
              <a:rPr lang="en-US" altLang="ko-KR" sz="1400" dirty="0"/>
              <a:t>95% limits of agreement: -3.061 to 3.409</a:t>
            </a:r>
          </a:p>
          <a:p>
            <a:pPr algn="ctr"/>
            <a:r>
              <a:rPr lang="en-US" altLang="ko-KR" sz="1400" dirty="0"/>
              <a:t> </a:t>
            </a:r>
            <a:endParaRPr lang="ko-KR" altLang="en-US" sz="1400" dirty="0"/>
          </a:p>
          <a:p>
            <a:r>
              <a:rPr lang="en-US" altLang="ko-KR" dirty="0"/>
              <a:t> </a:t>
            </a:r>
            <a:endParaRPr lang="ko-KR" altLang="en-US" dirty="0"/>
          </a:p>
        </p:txBody>
      </p:sp>
      <p:pic>
        <p:nvPicPr>
          <p:cNvPr id="41" name="그림 40" descr="텍스트, 스크린샷, 도표이(가) 표시된 사진&#10;&#10;자동 생성된 설명">
            <a:extLst>
              <a:ext uri="{FF2B5EF4-FFF2-40B4-BE49-F238E27FC236}">
                <a16:creationId xmlns:a16="http://schemas.microsoft.com/office/drawing/2014/main" id="{5A214A41-6125-1A42-AE2D-79CB4584ECF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70605" y="2410308"/>
            <a:ext cx="3709976" cy="3132852"/>
          </a:xfrm>
          <a:prstGeom prst="rect">
            <a:avLst/>
          </a:prstGeom>
        </p:spPr>
      </p:pic>
      <p:pic>
        <p:nvPicPr>
          <p:cNvPr id="42" name="그림 41" descr="텍스트, 스크린샷이(가) 표시된 사진&#10;&#10;자동 생성된 설명">
            <a:extLst>
              <a:ext uri="{FF2B5EF4-FFF2-40B4-BE49-F238E27FC236}">
                <a16:creationId xmlns:a16="http://schemas.microsoft.com/office/drawing/2014/main" id="{6F25A9B9-D76D-3E46-25B7-79D914A658F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665619" y="7605701"/>
            <a:ext cx="3358031" cy="3126998"/>
          </a:xfrm>
          <a:prstGeom prst="rect">
            <a:avLst/>
          </a:prstGeom>
        </p:spPr>
      </p:pic>
      <p:pic>
        <p:nvPicPr>
          <p:cNvPr id="43" name="그림 42" descr="텍스트, 스크린샷, 라인이(가) 표시된 사진&#10;&#10;자동 생성된 설명">
            <a:extLst>
              <a:ext uri="{FF2B5EF4-FFF2-40B4-BE49-F238E27FC236}">
                <a16:creationId xmlns:a16="http://schemas.microsoft.com/office/drawing/2014/main" id="{AF8077C5-FE9A-A0AF-1A5A-CD3D3B7AE75E}"/>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683780" y="7684962"/>
            <a:ext cx="3326075" cy="2989866"/>
          </a:xfrm>
          <a:prstGeom prst="rect">
            <a:avLst/>
          </a:prstGeom>
        </p:spPr>
      </p:pic>
      <p:pic>
        <p:nvPicPr>
          <p:cNvPr id="44" name="그림 43" descr="텍스트, 스크린샷, 도표, 라인이(가) 표시된 사진&#10;&#10;자동 생성된 설명">
            <a:extLst>
              <a:ext uri="{FF2B5EF4-FFF2-40B4-BE49-F238E27FC236}">
                <a16:creationId xmlns:a16="http://schemas.microsoft.com/office/drawing/2014/main" id="{3D3F847B-2BE8-9E25-E12D-17BCDF229CB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96253" y="7547827"/>
            <a:ext cx="3508425" cy="3132852"/>
          </a:xfrm>
          <a:prstGeom prst="rect">
            <a:avLst/>
          </a:prstGeom>
        </p:spPr>
      </p:pic>
      <p:sp>
        <p:nvSpPr>
          <p:cNvPr id="51" name="TextBox 50">
            <a:extLst>
              <a:ext uri="{FF2B5EF4-FFF2-40B4-BE49-F238E27FC236}">
                <a16:creationId xmlns:a16="http://schemas.microsoft.com/office/drawing/2014/main" id="{958350B1-BEF6-2452-8208-F4A3A8ED5EA4}"/>
              </a:ext>
            </a:extLst>
          </p:cNvPr>
          <p:cNvSpPr txBox="1"/>
          <p:nvPr/>
        </p:nvSpPr>
        <p:spPr>
          <a:xfrm>
            <a:off x="802583" y="6092746"/>
            <a:ext cx="3446023" cy="1292662"/>
          </a:xfrm>
          <a:prstGeom prst="rect">
            <a:avLst/>
          </a:prstGeom>
          <a:noFill/>
        </p:spPr>
        <p:txBody>
          <a:bodyPr wrap="square" rtlCol="0">
            <a:spAutoFit/>
          </a:bodyPr>
          <a:lstStyle/>
          <a:p>
            <a:r>
              <a:rPr lang="en-US" altLang="ko-KR" b="1" dirty="0"/>
              <a:t>(D)</a:t>
            </a:r>
            <a:r>
              <a:rPr lang="ko-KR" altLang="en-US" b="1" dirty="0"/>
              <a:t> </a:t>
            </a:r>
            <a:r>
              <a:rPr lang="en-US" altLang="ko-KR" b="1" dirty="0"/>
              <a:t>Agreement between actual </a:t>
            </a:r>
          </a:p>
          <a:p>
            <a:r>
              <a:rPr lang="en-US" altLang="ko-KR" b="1" dirty="0"/>
              <a:t>    and predicted ALM (Total)</a:t>
            </a:r>
          </a:p>
          <a:p>
            <a:pPr algn="ctr"/>
            <a:r>
              <a:rPr lang="en-US" altLang="ko-KR" sz="1400" dirty="0"/>
              <a:t>Mean difference: 0.180</a:t>
            </a:r>
          </a:p>
          <a:p>
            <a:pPr algn="ctr"/>
            <a:r>
              <a:rPr lang="en-US" altLang="ko-KR" sz="1400" dirty="0"/>
              <a:t>95% limits of agreement: -3.614 to 3.255 </a:t>
            </a:r>
          </a:p>
          <a:p>
            <a:pPr algn="ctr"/>
            <a:endParaRPr lang="ko-KR" altLang="en-US" sz="1400" dirty="0"/>
          </a:p>
        </p:txBody>
      </p:sp>
      <p:sp>
        <p:nvSpPr>
          <p:cNvPr id="52" name="TextBox 51">
            <a:extLst>
              <a:ext uri="{FF2B5EF4-FFF2-40B4-BE49-F238E27FC236}">
                <a16:creationId xmlns:a16="http://schemas.microsoft.com/office/drawing/2014/main" id="{AF566DC3-DBE2-50A7-D072-B6DF87688FC9}"/>
              </a:ext>
            </a:extLst>
          </p:cNvPr>
          <p:cNvSpPr txBox="1"/>
          <p:nvPr/>
        </p:nvSpPr>
        <p:spPr>
          <a:xfrm>
            <a:off x="4849780" y="6115299"/>
            <a:ext cx="3446023" cy="1569660"/>
          </a:xfrm>
          <a:prstGeom prst="rect">
            <a:avLst/>
          </a:prstGeom>
          <a:noFill/>
        </p:spPr>
        <p:txBody>
          <a:bodyPr wrap="square" rtlCol="0">
            <a:spAutoFit/>
          </a:bodyPr>
          <a:lstStyle/>
          <a:p>
            <a:r>
              <a:rPr lang="en-US" altLang="ko-KR" b="1" dirty="0"/>
              <a:t>(E) Agreement between actual </a:t>
            </a:r>
          </a:p>
          <a:p>
            <a:r>
              <a:rPr lang="en-US" altLang="ko-KR" b="1" dirty="0"/>
              <a:t>    and predicted ALM (Men)</a:t>
            </a:r>
          </a:p>
          <a:p>
            <a:pPr algn="ctr"/>
            <a:r>
              <a:rPr lang="en-US" altLang="ko-KR" sz="1400" dirty="0"/>
              <a:t>Mean difference: -0.313</a:t>
            </a:r>
          </a:p>
          <a:p>
            <a:pPr algn="ctr"/>
            <a:r>
              <a:rPr lang="en-US" altLang="ko-KR" sz="1400" dirty="0"/>
              <a:t>95% limits of agreement: -4.053 to 3.426</a:t>
            </a:r>
          </a:p>
          <a:p>
            <a:pPr algn="ctr"/>
            <a:r>
              <a:rPr lang="en-US" altLang="ko-KR" sz="1400" dirty="0"/>
              <a:t> </a:t>
            </a:r>
            <a:endParaRPr lang="ko-KR" altLang="en-US" sz="1400" dirty="0"/>
          </a:p>
          <a:p>
            <a:r>
              <a:rPr lang="en-US" altLang="ko-KR" dirty="0"/>
              <a:t> </a:t>
            </a:r>
            <a:endParaRPr lang="ko-KR" altLang="en-US" dirty="0"/>
          </a:p>
        </p:txBody>
      </p:sp>
      <p:sp>
        <p:nvSpPr>
          <p:cNvPr id="53" name="TextBox 52">
            <a:extLst>
              <a:ext uri="{FF2B5EF4-FFF2-40B4-BE49-F238E27FC236}">
                <a16:creationId xmlns:a16="http://schemas.microsoft.com/office/drawing/2014/main" id="{6D8DAF6A-D9D3-46E5-D0A4-12BAAAF7245E}"/>
              </a:ext>
            </a:extLst>
          </p:cNvPr>
          <p:cNvSpPr txBox="1"/>
          <p:nvPr/>
        </p:nvSpPr>
        <p:spPr>
          <a:xfrm>
            <a:off x="8665619" y="6156145"/>
            <a:ext cx="3610045" cy="1569660"/>
          </a:xfrm>
          <a:prstGeom prst="rect">
            <a:avLst/>
          </a:prstGeom>
          <a:noFill/>
        </p:spPr>
        <p:txBody>
          <a:bodyPr wrap="square" rtlCol="0">
            <a:spAutoFit/>
          </a:bodyPr>
          <a:lstStyle/>
          <a:p>
            <a:r>
              <a:rPr lang="en-US" altLang="ko-KR" b="1" dirty="0"/>
              <a:t>     (F) Agreement between actual </a:t>
            </a:r>
          </a:p>
          <a:p>
            <a:r>
              <a:rPr lang="en-US" altLang="ko-KR" b="1" dirty="0"/>
              <a:t>       and predicted ALM (Women)</a:t>
            </a:r>
          </a:p>
          <a:p>
            <a:pPr algn="ctr"/>
            <a:r>
              <a:rPr lang="en-US" altLang="ko-KR" sz="1400" dirty="0"/>
              <a:t>Mean difference: -0.139</a:t>
            </a:r>
          </a:p>
          <a:p>
            <a:pPr algn="ctr"/>
            <a:r>
              <a:rPr lang="en-US" altLang="ko-KR" sz="1400" dirty="0"/>
              <a:t>95% limits of agreement: -2.571 to 2.294 </a:t>
            </a:r>
          </a:p>
          <a:p>
            <a:pPr algn="ctr"/>
            <a:endParaRPr lang="ko-KR" altLang="en-US" sz="1400" dirty="0"/>
          </a:p>
          <a:p>
            <a:r>
              <a:rPr lang="en-US" altLang="ko-KR" dirty="0"/>
              <a:t> </a:t>
            </a:r>
            <a:endParaRPr lang="ko-KR" altLang="en-US" dirty="0"/>
          </a:p>
        </p:txBody>
      </p:sp>
      <p:sp>
        <p:nvSpPr>
          <p:cNvPr id="2" name="TextBox 1">
            <a:extLst>
              <a:ext uri="{FF2B5EF4-FFF2-40B4-BE49-F238E27FC236}">
                <a16:creationId xmlns:a16="http://schemas.microsoft.com/office/drawing/2014/main" id="{FD3CC9AA-26FA-3AD2-5616-B24CBD74D53A}"/>
              </a:ext>
            </a:extLst>
          </p:cNvPr>
          <p:cNvSpPr txBox="1"/>
          <p:nvPr/>
        </p:nvSpPr>
        <p:spPr>
          <a:xfrm rot="16200000">
            <a:off x="-850364" y="3305489"/>
            <a:ext cx="3305890" cy="261610"/>
          </a:xfrm>
          <a:prstGeom prst="rect">
            <a:avLst/>
          </a:prstGeom>
          <a:solidFill>
            <a:schemeClr val="bg1"/>
          </a:solidFill>
        </p:spPr>
        <p:txBody>
          <a:bodyPr wrap="square" rtlCol="0">
            <a:spAutoFit/>
          </a:bodyPr>
          <a:lstStyle/>
          <a:p>
            <a:r>
              <a:rPr lang="en-US" altLang="ko-KR" sz="1100" dirty="0"/>
              <a:t>Difference (Actual TFM - Predicted TFM)</a:t>
            </a:r>
            <a:endParaRPr lang="ko-KR" altLang="en-US" sz="1100" dirty="0"/>
          </a:p>
        </p:txBody>
      </p:sp>
      <p:sp>
        <p:nvSpPr>
          <p:cNvPr id="3" name="TextBox 2">
            <a:extLst>
              <a:ext uri="{FF2B5EF4-FFF2-40B4-BE49-F238E27FC236}">
                <a16:creationId xmlns:a16="http://schemas.microsoft.com/office/drawing/2014/main" id="{980E1B1C-5782-65BA-EB03-E4005B456A6F}"/>
              </a:ext>
            </a:extLst>
          </p:cNvPr>
          <p:cNvSpPr txBox="1"/>
          <p:nvPr/>
        </p:nvSpPr>
        <p:spPr>
          <a:xfrm rot="16200000">
            <a:off x="3179856" y="3305489"/>
            <a:ext cx="3305890" cy="261610"/>
          </a:xfrm>
          <a:prstGeom prst="rect">
            <a:avLst/>
          </a:prstGeom>
          <a:solidFill>
            <a:schemeClr val="bg1"/>
          </a:solidFill>
        </p:spPr>
        <p:txBody>
          <a:bodyPr wrap="square" rtlCol="0">
            <a:spAutoFit/>
          </a:bodyPr>
          <a:lstStyle/>
          <a:p>
            <a:r>
              <a:rPr lang="en-US" altLang="ko-KR" sz="1100" dirty="0"/>
              <a:t>Difference (Actual TFM - Predicted TFM)</a:t>
            </a:r>
            <a:endParaRPr lang="ko-KR" altLang="en-US" sz="1100" dirty="0"/>
          </a:p>
        </p:txBody>
      </p:sp>
      <p:sp>
        <p:nvSpPr>
          <p:cNvPr id="4" name="TextBox 3">
            <a:extLst>
              <a:ext uri="{FF2B5EF4-FFF2-40B4-BE49-F238E27FC236}">
                <a16:creationId xmlns:a16="http://schemas.microsoft.com/office/drawing/2014/main" id="{1C6B68EC-F57B-C1A5-8B87-27D3DE0EA4F8}"/>
              </a:ext>
            </a:extLst>
          </p:cNvPr>
          <p:cNvSpPr txBox="1"/>
          <p:nvPr/>
        </p:nvSpPr>
        <p:spPr>
          <a:xfrm rot="16200000">
            <a:off x="7106960" y="3291631"/>
            <a:ext cx="3305890" cy="261610"/>
          </a:xfrm>
          <a:prstGeom prst="rect">
            <a:avLst/>
          </a:prstGeom>
          <a:solidFill>
            <a:schemeClr val="bg1"/>
          </a:solidFill>
        </p:spPr>
        <p:txBody>
          <a:bodyPr wrap="square" rtlCol="0">
            <a:spAutoFit/>
          </a:bodyPr>
          <a:lstStyle/>
          <a:p>
            <a:r>
              <a:rPr lang="en-US" altLang="ko-KR" sz="1100" dirty="0"/>
              <a:t>Difference (Actual TFM - Predicted TFM)</a:t>
            </a:r>
            <a:endParaRPr lang="ko-KR" altLang="en-US" sz="1100" dirty="0"/>
          </a:p>
        </p:txBody>
      </p:sp>
      <p:sp>
        <p:nvSpPr>
          <p:cNvPr id="5" name="TextBox 4">
            <a:extLst>
              <a:ext uri="{FF2B5EF4-FFF2-40B4-BE49-F238E27FC236}">
                <a16:creationId xmlns:a16="http://schemas.microsoft.com/office/drawing/2014/main" id="{027AA216-DF50-0D66-EF32-BD54A8AA60B5}"/>
              </a:ext>
            </a:extLst>
          </p:cNvPr>
          <p:cNvSpPr txBox="1"/>
          <p:nvPr/>
        </p:nvSpPr>
        <p:spPr>
          <a:xfrm>
            <a:off x="835944" y="5412355"/>
            <a:ext cx="3602578" cy="261610"/>
          </a:xfrm>
          <a:prstGeom prst="rect">
            <a:avLst/>
          </a:prstGeom>
          <a:solidFill>
            <a:schemeClr val="bg1"/>
          </a:solidFill>
        </p:spPr>
        <p:txBody>
          <a:bodyPr wrap="square" rtlCol="0">
            <a:spAutoFit/>
          </a:bodyPr>
          <a:lstStyle/>
          <a:p>
            <a:r>
              <a:rPr lang="en-US" altLang="ko-KR" sz="1100" dirty="0"/>
              <a:t>                  Average of actual TFM and predicted TFM</a:t>
            </a:r>
            <a:endParaRPr lang="ko-KR" altLang="en-US" sz="1100" dirty="0"/>
          </a:p>
        </p:txBody>
      </p:sp>
      <p:sp>
        <p:nvSpPr>
          <p:cNvPr id="8" name="TextBox 7">
            <a:extLst>
              <a:ext uri="{FF2B5EF4-FFF2-40B4-BE49-F238E27FC236}">
                <a16:creationId xmlns:a16="http://schemas.microsoft.com/office/drawing/2014/main" id="{97DD32AB-1146-40EB-3909-3D199FAB0E30}"/>
              </a:ext>
            </a:extLst>
          </p:cNvPr>
          <p:cNvSpPr txBox="1"/>
          <p:nvPr/>
        </p:nvSpPr>
        <p:spPr>
          <a:xfrm rot="16200000">
            <a:off x="3163470" y="3318226"/>
            <a:ext cx="3305890" cy="261610"/>
          </a:xfrm>
          <a:prstGeom prst="rect">
            <a:avLst/>
          </a:prstGeom>
          <a:solidFill>
            <a:schemeClr val="bg1"/>
          </a:solidFill>
        </p:spPr>
        <p:txBody>
          <a:bodyPr wrap="square" rtlCol="0">
            <a:spAutoFit/>
          </a:bodyPr>
          <a:lstStyle/>
          <a:p>
            <a:r>
              <a:rPr lang="en-US" altLang="ko-KR" sz="1100" dirty="0"/>
              <a:t>Difference (Actual TFM - Predicted TFM)</a:t>
            </a:r>
            <a:endParaRPr lang="ko-KR" altLang="en-US" sz="1100" dirty="0"/>
          </a:p>
        </p:txBody>
      </p:sp>
      <p:sp>
        <p:nvSpPr>
          <p:cNvPr id="11" name="TextBox 10">
            <a:extLst>
              <a:ext uri="{FF2B5EF4-FFF2-40B4-BE49-F238E27FC236}">
                <a16:creationId xmlns:a16="http://schemas.microsoft.com/office/drawing/2014/main" id="{94EFB512-D4E6-2BFA-E7B7-A4AF376B498D}"/>
              </a:ext>
            </a:extLst>
          </p:cNvPr>
          <p:cNvSpPr txBox="1"/>
          <p:nvPr/>
        </p:nvSpPr>
        <p:spPr>
          <a:xfrm>
            <a:off x="4849778" y="5425092"/>
            <a:ext cx="3602578" cy="261610"/>
          </a:xfrm>
          <a:prstGeom prst="rect">
            <a:avLst/>
          </a:prstGeom>
          <a:solidFill>
            <a:schemeClr val="bg1"/>
          </a:solidFill>
        </p:spPr>
        <p:txBody>
          <a:bodyPr wrap="square" rtlCol="0">
            <a:spAutoFit/>
          </a:bodyPr>
          <a:lstStyle/>
          <a:p>
            <a:r>
              <a:rPr lang="en-US" altLang="ko-KR" sz="1100" dirty="0"/>
              <a:t>                  Average of actual TFM and predicted TFM</a:t>
            </a:r>
            <a:endParaRPr lang="ko-KR" altLang="en-US" sz="1100" dirty="0"/>
          </a:p>
        </p:txBody>
      </p:sp>
      <p:sp>
        <p:nvSpPr>
          <p:cNvPr id="12" name="TextBox 11">
            <a:extLst>
              <a:ext uri="{FF2B5EF4-FFF2-40B4-BE49-F238E27FC236}">
                <a16:creationId xmlns:a16="http://schemas.microsoft.com/office/drawing/2014/main" id="{7E9BFFAB-13B8-AF42-8201-87FBFDA58E42}"/>
              </a:ext>
            </a:extLst>
          </p:cNvPr>
          <p:cNvSpPr txBox="1"/>
          <p:nvPr/>
        </p:nvSpPr>
        <p:spPr>
          <a:xfrm rot="16200000">
            <a:off x="7124363" y="3291631"/>
            <a:ext cx="3305890" cy="261610"/>
          </a:xfrm>
          <a:prstGeom prst="rect">
            <a:avLst/>
          </a:prstGeom>
          <a:solidFill>
            <a:schemeClr val="bg1"/>
          </a:solidFill>
        </p:spPr>
        <p:txBody>
          <a:bodyPr wrap="square" rtlCol="0">
            <a:spAutoFit/>
          </a:bodyPr>
          <a:lstStyle/>
          <a:p>
            <a:r>
              <a:rPr lang="en-US" altLang="ko-KR" sz="1100" dirty="0"/>
              <a:t>Difference (Actual TFM - Predicted TFM)</a:t>
            </a:r>
            <a:endParaRPr lang="ko-KR" altLang="en-US" sz="1100" dirty="0"/>
          </a:p>
        </p:txBody>
      </p:sp>
      <p:sp>
        <p:nvSpPr>
          <p:cNvPr id="13" name="TextBox 12">
            <a:extLst>
              <a:ext uri="{FF2B5EF4-FFF2-40B4-BE49-F238E27FC236}">
                <a16:creationId xmlns:a16="http://schemas.microsoft.com/office/drawing/2014/main" id="{D471E572-B0C6-999F-59C2-61AD127B40F1}"/>
              </a:ext>
            </a:extLst>
          </p:cNvPr>
          <p:cNvSpPr txBox="1"/>
          <p:nvPr/>
        </p:nvSpPr>
        <p:spPr>
          <a:xfrm>
            <a:off x="8810671" y="5398497"/>
            <a:ext cx="3602578" cy="261610"/>
          </a:xfrm>
          <a:prstGeom prst="rect">
            <a:avLst/>
          </a:prstGeom>
          <a:solidFill>
            <a:schemeClr val="bg1"/>
          </a:solidFill>
        </p:spPr>
        <p:txBody>
          <a:bodyPr wrap="square" rtlCol="0">
            <a:spAutoFit/>
          </a:bodyPr>
          <a:lstStyle/>
          <a:p>
            <a:r>
              <a:rPr lang="en-US" altLang="ko-KR" sz="1100" dirty="0"/>
              <a:t>                  Average of actual TFM and predicted TFM</a:t>
            </a:r>
            <a:endParaRPr lang="ko-KR" altLang="en-US" sz="1100" dirty="0"/>
          </a:p>
        </p:txBody>
      </p:sp>
      <p:sp>
        <p:nvSpPr>
          <p:cNvPr id="15" name="TextBox 14">
            <a:extLst>
              <a:ext uri="{FF2B5EF4-FFF2-40B4-BE49-F238E27FC236}">
                <a16:creationId xmlns:a16="http://schemas.microsoft.com/office/drawing/2014/main" id="{832C9E58-ED44-A228-42DE-08C68783B30B}"/>
              </a:ext>
            </a:extLst>
          </p:cNvPr>
          <p:cNvSpPr txBox="1"/>
          <p:nvPr/>
        </p:nvSpPr>
        <p:spPr>
          <a:xfrm rot="16200000">
            <a:off x="-1089375" y="8779694"/>
            <a:ext cx="3305890" cy="261610"/>
          </a:xfrm>
          <a:prstGeom prst="rect">
            <a:avLst/>
          </a:prstGeom>
          <a:solidFill>
            <a:schemeClr val="bg1"/>
          </a:solidFill>
        </p:spPr>
        <p:txBody>
          <a:bodyPr wrap="square" rtlCol="0">
            <a:spAutoFit/>
          </a:bodyPr>
          <a:lstStyle/>
          <a:p>
            <a:r>
              <a:rPr lang="en-US" altLang="ko-KR" sz="1100" dirty="0"/>
              <a:t>         Difference (Actual ALM - Predicted ALM)</a:t>
            </a:r>
            <a:endParaRPr lang="ko-KR" altLang="en-US" sz="1100" dirty="0"/>
          </a:p>
        </p:txBody>
      </p:sp>
      <p:sp>
        <p:nvSpPr>
          <p:cNvPr id="16" name="TextBox 15">
            <a:extLst>
              <a:ext uri="{FF2B5EF4-FFF2-40B4-BE49-F238E27FC236}">
                <a16:creationId xmlns:a16="http://schemas.microsoft.com/office/drawing/2014/main" id="{A115F86F-7F57-9521-2997-8B0366BA61C1}"/>
              </a:ext>
            </a:extLst>
          </p:cNvPr>
          <p:cNvSpPr txBox="1"/>
          <p:nvPr/>
        </p:nvSpPr>
        <p:spPr>
          <a:xfrm>
            <a:off x="483261" y="10558405"/>
            <a:ext cx="3602578" cy="261610"/>
          </a:xfrm>
          <a:prstGeom prst="rect">
            <a:avLst/>
          </a:prstGeom>
          <a:solidFill>
            <a:schemeClr val="bg1"/>
          </a:solidFill>
        </p:spPr>
        <p:txBody>
          <a:bodyPr wrap="square" rtlCol="0">
            <a:spAutoFit/>
          </a:bodyPr>
          <a:lstStyle/>
          <a:p>
            <a:r>
              <a:rPr lang="en-US" altLang="ko-KR" sz="1100" dirty="0"/>
              <a:t>                  Average of actual ALM and predicted ALM</a:t>
            </a:r>
            <a:endParaRPr lang="ko-KR" altLang="en-US" sz="1100" dirty="0"/>
          </a:p>
        </p:txBody>
      </p:sp>
      <p:sp>
        <p:nvSpPr>
          <p:cNvPr id="18" name="TextBox 17">
            <a:extLst>
              <a:ext uri="{FF2B5EF4-FFF2-40B4-BE49-F238E27FC236}">
                <a16:creationId xmlns:a16="http://schemas.microsoft.com/office/drawing/2014/main" id="{2C7B121F-3BEF-3CE1-756F-B8BCEA464733}"/>
              </a:ext>
            </a:extLst>
          </p:cNvPr>
          <p:cNvSpPr txBox="1"/>
          <p:nvPr/>
        </p:nvSpPr>
        <p:spPr>
          <a:xfrm rot="16200000">
            <a:off x="3066028" y="8847553"/>
            <a:ext cx="3305890" cy="261610"/>
          </a:xfrm>
          <a:prstGeom prst="rect">
            <a:avLst/>
          </a:prstGeom>
          <a:solidFill>
            <a:schemeClr val="bg1"/>
          </a:solidFill>
        </p:spPr>
        <p:txBody>
          <a:bodyPr wrap="square" rtlCol="0">
            <a:spAutoFit/>
          </a:bodyPr>
          <a:lstStyle/>
          <a:p>
            <a:r>
              <a:rPr lang="en-US" altLang="ko-KR" sz="1100" dirty="0"/>
              <a:t>         Difference (Actual ALM - Predicted ALM)</a:t>
            </a:r>
            <a:endParaRPr lang="ko-KR" altLang="en-US" sz="1100" dirty="0"/>
          </a:p>
        </p:txBody>
      </p:sp>
      <p:sp>
        <p:nvSpPr>
          <p:cNvPr id="19" name="TextBox 18">
            <a:extLst>
              <a:ext uri="{FF2B5EF4-FFF2-40B4-BE49-F238E27FC236}">
                <a16:creationId xmlns:a16="http://schemas.microsoft.com/office/drawing/2014/main" id="{C19EFB19-09EC-89F1-A1C2-F48AD3F1B295}"/>
              </a:ext>
            </a:extLst>
          </p:cNvPr>
          <p:cNvSpPr txBox="1"/>
          <p:nvPr/>
        </p:nvSpPr>
        <p:spPr>
          <a:xfrm>
            <a:off x="4671947" y="10532292"/>
            <a:ext cx="3602578" cy="261610"/>
          </a:xfrm>
          <a:prstGeom prst="rect">
            <a:avLst/>
          </a:prstGeom>
          <a:solidFill>
            <a:schemeClr val="bg1"/>
          </a:solidFill>
        </p:spPr>
        <p:txBody>
          <a:bodyPr wrap="square" rtlCol="0">
            <a:spAutoFit/>
          </a:bodyPr>
          <a:lstStyle/>
          <a:p>
            <a:r>
              <a:rPr lang="en-US" altLang="ko-KR" sz="1100" dirty="0"/>
              <a:t>                  Average of actual ALM and predicted ALM</a:t>
            </a:r>
            <a:endParaRPr lang="ko-KR" altLang="en-US" sz="1100" dirty="0"/>
          </a:p>
        </p:txBody>
      </p:sp>
      <p:sp>
        <p:nvSpPr>
          <p:cNvPr id="21" name="TextBox 20">
            <a:extLst>
              <a:ext uri="{FF2B5EF4-FFF2-40B4-BE49-F238E27FC236}">
                <a16:creationId xmlns:a16="http://schemas.microsoft.com/office/drawing/2014/main" id="{52B25AC5-F550-547A-7C3C-5CC42318BBBC}"/>
              </a:ext>
            </a:extLst>
          </p:cNvPr>
          <p:cNvSpPr txBox="1"/>
          <p:nvPr/>
        </p:nvSpPr>
        <p:spPr>
          <a:xfrm rot="16200000">
            <a:off x="7060877" y="8948948"/>
            <a:ext cx="3305890" cy="261610"/>
          </a:xfrm>
          <a:prstGeom prst="rect">
            <a:avLst/>
          </a:prstGeom>
          <a:solidFill>
            <a:schemeClr val="bg1"/>
          </a:solidFill>
        </p:spPr>
        <p:txBody>
          <a:bodyPr wrap="square" rtlCol="0">
            <a:spAutoFit/>
          </a:bodyPr>
          <a:lstStyle/>
          <a:p>
            <a:r>
              <a:rPr lang="en-US" altLang="ko-KR" sz="1100" dirty="0"/>
              <a:t>         Difference (Actual ALM - Predicted ALM)</a:t>
            </a:r>
            <a:endParaRPr lang="ko-KR" altLang="en-US" sz="1100" dirty="0"/>
          </a:p>
        </p:txBody>
      </p:sp>
      <p:sp>
        <p:nvSpPr>
          <p:cNvPr id="22" name="TextBox 21">
            <a:extLst>
              <a:ext uri="{FF2B5EF4-FFF2-40B4-BE49-F238E27FC236}">
                <a16:creationId xmlns:a16="http://schemas.microsoft.com/office/drawing/2014/main" id="{F38EBE54-0362-C1B9-13EE-13306B3E6B30}"/>
              </a:ext>
            </a:extLst>
          </p:cNvPr>
          <p:cNvSpPr txBox="1"/>
          <p:nvPr/>
        </p:nvSpPr>
        <p:spPr>
          <a:xfrm>
            <a:off x="8646503" y="10598275"/>
            <a:ext cx="3602578" cy="261610"/>
          </a:xfrm>
          <a:prstGeom prst="rect">
            <a:avLst/>
          </a:prstGeom>
          <a:solidFill>
            <a:schemeClr val="bg1"/>
          </a:solidFill>
        </p:spPr>
        <p:txBody>
          <a:bodyPr wrap="square" rtlCol="0">
            <a:spAutoFit/>
          </a:bodyPr>
          <a:lstStyle/>
          <a:p>
            <a:r>
              <a:rPr lang="en-US" altLang="ko-KR" sz="1100" dirty="0"/>
              <a:t>                  Average of actual ALM and predicted ALM</a:t>
            </a:r>
            <a:endParaRPr lang="ko-KR" altLang="en-US" sz="1100" dirty="0"/>
          </a:p>
        </p:txBody>
      </p:sp>
      <p:sp>
        <p:nvSpPr>
          <p:cNvPr id="9" name="TextBox 8">
            <a:extLst>
              <a:ext uri="{FF2B5EF4-FFF2-40B4-BE49-F238E27FC236}">
                <a16:creationId xmlns:a16="http://schemas.microsoft.com/office/drawing/2014/main" id="{C38CFEB1-5D97-15BA-1BB8-A579D9511F5B}"/>
              </a:ext>
            </a:extLst>
          </p:cNvPr>
          <p:cNvSpPr txBox="1"/>
          <p:nvPr/>
        </p:nvSpPr>
        <p:spPr>
          <a:xfrm>
            <a:off x="-4907" y="43317"/>
            <a:ext cx="12956287" cy="646331"/>
          </a:xfrm>
          <a:prstGeom prst="rect">
            <a:avLst/>
          </a:prstGeom>
          <a:noFill/>
        </p:spPr>
        <p:txBody>
          <a:bodyPr wrap="square" rtlCol="0">
            <a:spAutoFit/>
          </a:bodyPr>
          <a:lstStyle/>
          <a:p>
            <a:r>
              <a:rPr lang="en-US" altLang="ko-KR" b="1"/>
              <a:t>Supplementary </a:t>
            </a:r>
            <a:r>
              <a:rPr lang="en-US" altLang="ko-KR" b="1" dirty="0"/>
              <a:t>Figure 1. </a:t>
            </a:r>
            <a:r>
              <a:rPr lang="en-US" altLang="ko-KR" dirty="0"/>
              <a:t>Bland-Altman plots for evaluating differences in actual and predicted values of trunk fat mass (TFM) and appendicular lean mass (ALM) in adult cancer survivors in the Korean National Health and Nutrition Examination Survey (2008-2011) </a:t>
            </a:r>
            <a:endParaRPr lang="ko-KR" altLang="en-US" b="1" dirty="0"/>
          </a:p>
        </p:txBody>
      </p:sp>
    </p:spTree>
    <p:extLst>
      <p:ext uri="{BB962C8B-B14F-4D97-AF65-F5344CB8AC3E}">
        <p14:creationId xmlns:p14="http://schemas.microsoft.com/office/powerpoint/2010/main" val="648833912"/>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65</TotalTime>
  <Words>330</Words>
  <Application>Microsoft Office PowerPoint</Application>
  <PresentationFormat>사용자 지정</PresentationFormat>
  <Paragraphs>49</Paragraphs>
  <Slides>1</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1</vt:i4>
      </vt:variant>
    </vt:vector>
  </HeadingPairs>
  <TitlesOfParts>
    <vt:vector size="5" baseType="lpstr">
      <vt:lpstr>Arial</vt:lpstr>
      <vt:lpstr>Calibri</vt:lpstr>
      <vt:lpstr>Calibri Light</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국립암센터 호스피스완화의료사업과</dc:creator>
  <cp:lastModifiedBy>NCC</cp:lastModifiedBy>
  <cp:revision>6</cp:revision>
  <dcterms:created xsi:type="dcterms:W3CDTF">2023-07-03T23:34:17Z</dcterms:created>
  <dcterms:modified xsi:type="dcterms:W3CDTF">2023-12-27T04:49:03Z</dcterms:modified>
</cp:coreProperties>
</file>